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5"/>
  </p:notesMasterIdLst>
  <p:sldIdLst>
    <p:sldId id="261" r:id="rId3"/>
    <p:sldId id="262" r:id="rId4"/>
  </p:sldIdLst>
  <p:sldSz cx="7562850" cy="10688638"/>
  <p:notesSz cx="6858000" cy="9144000"/>
  <p:defaultTextStyle>
    <a:defPPr>
      <a:defRPr lang="en-US"/>
    </a:defPPr>
    <a:lvl1pPr marL="0" algn="l" defTabSz="9142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18" algn="l" defTabSz="9142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37" algn="l" defTabSz="9142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54" algn="l" defTabSz="9142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474" algn="l" defTabSz="9142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593" algn="l" defTabSz="9142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712" algn="l" defTabSz="9142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830" algn="l" defTabSz="9142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948" algn="l" defTabSz="91423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7" userDrawn="1">
          <p15:clr>
            <a:srgbClr val="A4A3A4"/>
          </p15:clr>
        </p15:guide>
        <p15:guide id="2" pos="23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1" d="100"/>
          <a:sy n="41" d="100"/>
        </p:scale>
        <p:origin x="2346" y="78"/>
      </p:cViewPr>
      <p:guideLst>
        <p:guide orient="horz" pos="3367"/>
        <p:guide pos="23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afi%20ullah%20Wazir\Downloads\paper%20data-for%20rafi%20to%20prepare%20graphs.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afi%20ullah%20Wazir\Downloads\paper%20data-for%20rafi%20to%20prepare%20graphs.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afi%20ullah%20Wazir\Downloads\paper%20data-for%20rafi%20to%20prepare%20graphs.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afi%20ullah%20Wazir\Downloads\paper%20data-for%20rafi%20to%20prepare%20graphs.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afi%20ullah%20Wazir\Downloads\paper%20data-for%20rafi%20to%20prepare%20graphs.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afi%20ullah%20Wazir\Downloads\paper%20data-for%20rafi%20to%20prepare%20graphs.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afi%20ullah%20Wazir\Downloads\paper%20data-for%20rafi%20to%20prepare%20graphs.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afi%20ullah%20Wazir\Downloads\paper%20data-for%20rafi%20to%20prepare%20graphs.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afi%20ullah%20Wazir\Downloads\paper%20data-for%20rafi%20to%20prepare%20graphs.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Refined Data from Peat M'!$V$16:$V$20</c:f>
                <c:numCache>
                  <c:formatCode>General</c:formatCode>
                  <c:ptCount val="5"/>
                  <c:pt idx="0">
                    <c:v>12.288205729999998</c:v>
                  </c:pt>
                  <c:pt idx="1">
                    <c:v>54.808758420000004</c:v>
                  </c:pt>
                  <c:pt idx="2">
                    <c:v>1.5275252319999997</c:v>
                  </c:pt>
                  <c:pt idx="3">
                    <c:v>15.373136740000001</c:v>
                  </c:pt>
                  <c:pt idx="4">
                    <c:v>7.5718777940000006</c:v>
                  </c:pt>
                </c:numCache>
              </c:numRef>
            </c:plus>
            <c:minus>
              <c:numRef>
                <c:f>'Refined Data from Peat M'!$V$16:$V$20</c:f>
                <c:numCache>
                  <c:formatCode>General</c:formatCode>
                  <c:ptCount val="5"/>
                  <c:pt idx="0">
                    <c:v>12.288205729999998</c:v>
                  </c:pt>
                  <c:pt idx="1">
                    <c:v>54.808758420000004</c:v>
                  </c:pt>
                  <c:pt idx="2">
                    <c:v>1.5275252319999997</c:v>
                  </c:pt>
                  <c:pt idx="3">
                    <c:v>15.373136740000001</c:v>
                  </c:pt>
                  <c:pt idx="4">
                    <c:v>7.5718777940000006</c:v>
                  </c:pt>
                </c:numCache>
              </c:numRef>
            </c:minus>
          </c:errBars>
          <c:cat>
            <c:strRef>
              <c:f>'Refined Data from Peat M'!$T$16:$T$20</c:f>
              <c:strCache>
                <c:ptCount val="5"/>
                <c:pt idx="0">
                  <c:v>Control</c:v>
                </c:pt>
                <c:pt idx="1">
                  <c:v>SMK 1:500</c:v>
                </c:pt>
                <c:pt idx="2">
                  <c:v>SMK 1:250</c:v>
                </c:pt>
                <c:pt idx="3">
                  <c:v>BGD 50:50</c:v>
                </c:pt>
                <c:pt idx="4">
                  <c:v>BGD 75:25</c:v>
                </c:pt>
              </c:strCache>
            </c:strRef>
          </c:cat>
          <c:val>
            <c:numRef>
              <c:f>'Refined Data from Peat M'!$U$16:$U$20</c:f>
              <c:numCache>
                <c:formatCode>General</c:formatCode>
                <c:ptCount val="5"/>
                <c:pt idx="0">
                  <c:v>239</c:v>
                </c:pt>
                <c:pt idx="1">
                  <c:v>241</c:v>
                </c:pt>
                <c:pt idx="2">
                  <c:v>256.33333329999994</c:v>
                </c:pt>
                <c:pt idx="3">
                  <c:v>268.33333329999994</c:v>
                </c:pt>
                <c:pt idx="4">
                  <c:v>247.6666666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98-441E-ADCD-878E6563A6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57721216"/>
        <c:axId val="57722752"/>
      </c:barChart>
      <c:catAx>
        <c:axId val="57721216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crossAx val="57722752"/>
        <c:crosses val="autoZero"/>
        <c:auto val="1"/>
        <c:lblAlgn val="ctr"/>
        <c:lblOffset val="100"/>
        <c:noMultiLvlLbl val="0"/>
      </c:catAx>
      <c:valAx>
        <c:axId val="577227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5772121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664541752168391"/>
          <c:y val="5.8489691740864901E-2"/>
          <c:w val="0.80336149439816273"/>
          <c:h val="0.717029381743948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Refine data from Fld RI'!$AC$16:$AC$20</c:f>
                <c:numCache>
                  <c:formatCode>General</c:formatCode>
                  <c:ptCount val="5"/>
                  <c:pt idx="0">
                    <c:v>6.2449979979999988</c:v>
                  </c:pt>
                  <c:pt idx="1">
                    <c:v>13.012814200000001</c:v>
                  </c:pt>
                  <c:pt idx="2">
                    <c:v>9.1651513900000001</c:v>
                  </c:pt>
                  <c:pt idx="3">
                    <c:v>4.7258156259999984</c:v>
                  </c:pt>
                  <c:pt idx="4">
                    <c:v>19.28730152</c:v>
                  </c:pt>
                </c:numCache>
              </c:numRef>
            </c:plus>
            <c:minus>
              <c:numRef>
                <c:f>'Refine data from Fld RI'!$AC$16:$AC$20</c:f>
                <c:numCache>
                  <c:formatCode>General</c:formatCode>
                  <c:ptCount val="5"/>
                  <c:pt idx="0">
                    <c:v>6.2449979979999988</c:v>
                  </c:pt>
                  <c:pt idx="1">
                    <c:v>13.012814200000001</c:v>
                  </c:pt>
                  <c:pt idx="2">
                    <c:v>9.1651513900000001</c:v>
                  </c:pt>
                  <c:pt idx="3">
                    <c:v>4.7258156259999984</c:v>
                  </c:pt>
                  <c:pt idx="4">
                    <c:v>19.28730152</c:v>
                  </c:pt>
                </c:numCache>
              </c:numRef>
            </c:minus>
          </c:errBars>
          <c:cat>
            <c:strRef>
              <c:f>'Refine data from Fld RI'!$AA$16:$AA$20</c:f>
              <c:strCache>
                <c:ptCount val="5"/>
                <c:pt idx="0">
                  <c:v>Control</c:v>
                </c:pt>
                <c:pt idx="1">
                  <c:v>SMK 1:500</c:v>
                </c:pt>
                <c:pt idx="2">
                  <c:v>SMK 1:250</c:v>
                </c:pt>
                <c:pt idx="3">
                  <c:v>BGD 50:50</c:v>
                </c:pt>
                <c:pt idx="4">
                  <c:v>BGD 75:25</c:v>
                </c:pt>
              </c:strCache>
            </c:strRef>
          </c:cat>
          <c:val>
            <c:numRef>
              <c:f>'Refine data from Fld RI'!$AB$16:$AB$20</c:f>
              <c:numCache>
                <c:formatCode>General</c:formatCode>
                <c:ptCount val="5"/>
                <c:pt idx="0">
                  <c:v>293</c:v>
                </c:pt>
                <c:pt idx="1">
                  <c:v>292.66666670000001</c:v>
                </c:pt>
                <c:pt idx="2">
                  <c:v>262</c:v>
                </c:pt>
                <c:pt idx="3">
                  <c:v>283.66666670000001</c:v>
                </c:pt>
                <c:pt idx="4">
                  <c:v>3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F8-4FA1-92CC-44E92E4055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58018816"/>
        <c:axId val="58181504"/>
      </c:barChart>
      <c:catAx>
        <c:axId val="58018816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crossAx val="58181504"/>
        <c:crosses val="autoZero"/>
        <c:auto val="1"/>
        <c:lblAlgn val="ctr"/>
        <c:lblOffset val="100"/>
        <c:noMultiLvlLbl val="0"/>
      </c:catAx>
      <c:valAx>
        <c:axId val="58181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580188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406174412022027"/>
          <c:y val="5.1400554097404488E-2"/>
          <c:w val="0.84046916010498685"/>
          <c:h val="0.6998455271216097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Refined Data from Peat M'!$V$44:$V$48</c:f>
                <c:numCache>
                  <c:formatCode>General</c:formatCode>
                  <c:ptCount val="5"/>
                  <c:pt idx="0">
                    <c:v>0.34210135000000003</c:v>
                  </c:pt>
                  <c:pt idx="1">
                    <c:v>0.2565800720000001</c:v>
                  </c:pt>
                  <c:pt idx="2">
                    <c:v>0.13316656199999996</c:v>
                  </c:pt>
                  <c:pt idx="3">
                    <c:v>0.14730919900000003</c:v>
                  </c:pt>
                  <c:pt idx="4">
                    <c:v>0.190087699</c:v>
                  </c:pt>
                </c:numCache>
              </c:numRef>
            </c:plus>
            <c:minus>
              <c:numRef>
                <c:f>'Refined Data from Peat M'!$V$44:$V$48</c:f>
                <c:numCache>
                  <c:formatCode>General</c:formatCode>
                  <c:ptCount val="5"/>
                  <c:pt idx="0">
                    <c:v>0.34210135000000003</c:v>
                  </c:pt>
                  <c:pt idx="1">
                    <c:v>0.2565800720000001</c:v>
                  </c:pt>
                  <c:pt idx="2">
                    <c:v>0.13316656199999996</c:v>
                  </c:pt>
                  <c:pt idx="3">
                    <c:v>0.14730919900000003</c:v>
                  </c:pt>
                  <c:pt idx="4">
                    <c:v>0.190087699</c:v>
                  </c:pt>
                </c:numCache>
              </c:numRef>
            </c:minus>
          </c:errBars>
          <c:cat>
            <c:strRef>
              <c:f>'Refined Data from Peat M'!$T$44:$T$48</c:f>
              <c:strCache>
                <c:ptCount val="5"/>
                <c:pt idx="0">
                  <c:v>Control</c:v>
                </c:pt>
                <c:pt idx="1">
                  <c:v>SMK 1:500</c:v>
                </c:pt>
                <c:pt idx="2">
                  <c:v>SMK 1:250</c:v>
                </c:pt>
                <c:pt idx="3">
                  <c:v>BGD 50:50</c:v>
                </c:pt>
                <c:pt idx="4">
                  <c:v>BGD 75:25</c:v>
                </c:pt>
              </c:strCache>
            </c:strRef>
          </c:cat>
          <c:val>
            <c:numRef>
              <c:f>'Refined Data from Peat M'!$U$44:$U$48</c:f>
              <c:numCache>
                <c:formatCode>General</c:formatCode>
                <c:ptCount val="5"/>
                <c:pt idx="0">
                  <c:v>2.153333333</c:v>
                </c:pt>
                <c:pt idx="1">
                  <c:v>2.3933333329999997</c:v>
                </c:pt>
                <c:pt idx="2">
                  <c:v>2.1766666669999997</c:v>
                </c:pt>
                <c:pt idx="3">
                  <c:v>2.73</c:v>
                </c:pt>
                <c:pt idx="4">
                  <c:v>2.516666666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71-4A1C-BBF6-A244510BE7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57678848"/>
        <c:axId val="57680640"/>
      </c:barChart>
      <c:catAx>
        <c:axId val="57678848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crossAx val="57680640"/>
        <c:crosses val="autoZero"/>
        <c:auto val="1"/>
        <c:lblAlgn val="ctr"/>
        <c:lblOffset val="100"/>
        <c:noMultiLvlLbl val="0"/>
      </c:catAx>
      <c:valAx>
        <c:axId val="57680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576788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86987288353661"/>
          <c:y val="8.0998397475251227E-2"/>
          <c:w val="0.82884630230044776"/>
          <c:h val="0.6915878353747447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Refine data from Fld RI'!$AC$44:$AC$48</c:f>
                <c:numCache>
                  <c:formatCode>General</c:formatCode>
                  <c:ptCount val="5"/>
                  <c:pt idx="0">
                    <c:v>0.18193405400000004</c:v>
                  </c:pt>
                  <c:pt idx="1">
                    <c:v>0.44523402099999992</c:v>
                  </c:pt>
                  <c:pt idx="2">
                    <c:v>0.5188448710000001</c:v>
                  </c:pt>
                  <c:pt idx="3">
                    <c:v>0.22068076499999997</c:v>
                  </c:pt>
                  <c:pt idx="4">
                    <c:v>8.3864971000000038E-2</c:v>
                  </c:pt>
                </c:numCache>
              </c:numRef>
            </c:plus>
            <c:minus>
              <c:numRef>
                <c:f>'Refine data from Fld RI'!$AC$44:$AC$48</c:f>
                <c:numCache>
                  <c:formatCode>General</c:formatCode>
                  <c:ptCount val="5"/>
                  <c:pt idx="0">
                    <c:v>0.18193405400000004</c:v>
                  </c:pt>
                  <c:pt idx="1">
                    <c:v>0.44523402099999992</c:v>
                  </c:pt>
                  <c:pt idx="2">
                    <c:v>0.5188448710000001</c:v>
                  </c:pt>
                  <c:pt idx="3">
                    <c:v>0.22068076499999997</c:v>
                  </c:pt>
                  <c:pt idx="4">
                    <c:v>8.3864971000000038E-2</c:v>
                  </c:pt>
                </c:numCache>
              </c:numRef>
            </c:minus>
          </c:errBars>
          <c:cat>
            <c:strRef>
              <c:f>'Refine data from Fld RI'!$AA$44:$AA$48</c:f>
              <c:strCache>
                <c:ptCount val="5"/>
                <c:pt idx="0">
                  <c:v>Control</c:v>
                </c:pt>
                <c:pt idx="1">
                  <c:v>SMK 1:500</c:v>
                </c:pt>
                <c:pt idx="2">
                  <c:v>SMK 1:250</c:v>
                </c:pt>
                <c:pt idx="3">
                  <c:v>BGD 50:50</c:v>
                </c:pt>
                <c:pt idx="4">
                  <c:v>BGD 75:25</c:v>
                </c:pt>
              </c:strCache>
            </c:strRef>
          </c:cat>
          <c:val>
            <c:numRef>
              <c:f>'Refine data from Fld RI'!$AB$44:$AB$48</c:f>
              <c:numCache>
                <c:formatCode>General</c:formatCode>
                <c:ptCount val="5"/>
                <c:pt idx="0">
                  <c:v>4.63</c:v>
                </c:pt>
                <c:pt idx="1">
                  <c:v>4.3733333329999997</c:v>
                </c:pt>
                <c:pt idx="2">
                  <c:v>4.3899999999999997</c:v>
                </c:pt>
                <c:pt idx="3">
                  <c:v>4.7699999999999996</c:v>
                </c:pt>
                <c:pt idx="4">
                  <c:v>4.763333333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383-41F9-B301-E1326AF5F6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58153984"/>
        <c:axId val="58272768"/>
      </c:barChart>
      <c:catAx>
        <c:axId val="5815398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crossAx val="58272768"/>
        <c:crosses val="autoZero"/>
        <c:auto val="1"/>
        <c:lblAlgn val="ctr"/>
        <c:lblOffset val="100"/>
        <c:noMultiLvlLbl val="0"/>
      </c:catAx>
      <c:valAx>
        <c:axId val="582727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581539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778684833513457"/>
          <c:y val="3.5271357209381099E-2"/>
          <c:w val="0.84221315166486543"/>
          <c:h val="0.798225065616797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Refined Data from Peat M'!$V$30:$V$34</c:f>
                <c:numCache>
                  <c:formatCode>General</c:formatCode>
                  <c:ptCount val="5"/>
                  <c:pt idx="0">
                    <c:v>2.5166114999999999E-2</c:v>
                  </c:pt>
                  <c:pt idx="1">
                    <c:v>1.1547005000000004E-2</c:v>
                  </c:pt>
                  <c:pt idx="2">
                    <c:v>2.6457513000000005E-2</c:v>
                  </c:pt>
                  <c:pt idx="3">
                    <c:v>2.0000000000000004E-2</c:v>
                  </c:pt>
                  <c:pt idx="4">
                    <c:v>1.0000000000000002E-2</c:v>
                  </c:pt>
                </c:numCache>
              </c:numRef>
            </c:plus>
            <c:minus>
              <c:numRef>
                <c:f>'Refined Data from Peat M'!$V$30:$V$34</c:f>
                <c:numCache>
                  <c:formatCode>General</c:formatCode>
                  <c:ptCount val="5"/>
                  <c:pt idx="0">
                    <c:v>2.5166114999999999E-2</c:v>
                  </c:pt>
                  <c:pt idx="1">
                    <c:v>1.1547005000000004E-2</c:v>
                  </c:pt>
                  <c:pt idx="2">
                    <c:v>2.6457513000000005E-2</c:v>
                  </c:pt>
                  <c:pt idx="3">
                    <c:v>2.0000000000000004E-2</c:v>
                  </c:pt>
                  <c:pt idx="4">
                    <c:v>1.0000000000000002E-2</c:v>
                  </c:pt>
                </c:numCache>
              </c:numRef>
            </c:minus>
          </c:errBars>
          <c:cat>
            <c:strRef>
              <c:f>'Refined Data from Peat M'!$T$30:$T$34</c:f>
              <c:strCache>
                <c:ptCount val="5"/>
                <c:pt idx="0">
                  <c:v>Control</c:v>
                </c:pt>
                <c:pt idx="1">
                  <c:v>SMK 1:500</c:v>
                </c:pt>
                <c:pt idx="2">
                  <c:v>SMK 1:250</c:v>
                </c:pt>
                <c:pt idx="3">
                  <c:v>BGD 50:50</c:v>
                </c:pt>
                <c:pt idx="4">
                  <c:v>BGD 75:25</c:v>
                </c:pt>
              </c:strCache>
            </c:strRef>
          </c:cat>
          <c:val>
            <c:numRef>
              <c:f>'Refined Data from Peat M'!$U$30:$U$34</c:f>
              <c:numCache>
                <c:formatCode>General</c:formatCode>
                <c:ptCount val="5"/>
                <c:pt idx="0">
                  <c:v>0.16666666699999999</c:v>
                </c:pt>
                <c:pt idx="1">
                  <c:v>0.176666667</c:v>
                </c:pt>
                <c:pt idx="2">
                  <c:v>0.18000000000000002</c:v>
                </c:pt>
                <c:pt idx="3">
                  <c:v>0.19000000000000003</c:v>
                </c:pt>
                <c:pt idx="4">
                  <c:v>0.18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DE-4BD1-835C-7C5115079D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89753472"/>
        <c:axId val="89755008"/>
      </c:barChart>
      <c:catAx>
        <c:axId val="89753472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crossAx val="89755008"/>
        <c:crosses val="autoZero"/>
        <c:auto val="1"/>
        <c:lblAlgn val="ctr"/>
        <c:lblOffset val="100"/>
        <c:noMultiLvlLbl val="0"/>
      </c:catAx>
      <c:valAx>
        <c:axId val="897550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897534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823497246667696"/>
          <c:y val="6.5578302712160932E-2"/>
          <c:w val="0.80375816993464055"/>
          <c:h val="0.71745270122484694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Refine data from Fld RI'!$AC$30:$AC$34</c:f>
                <c:numCache>
                  <c:formatCode>General</c:formatCode>
                  <c:ptCount val="5"/>
                  <c:pt idx="0">
                    <c:v>0.42712215300000006</c:v>
                  </c:pt>
                  <c:pt idx="1">
                    <c:v>0.41146081200000006</c:v>
                  </c:pt>
                  <c:pt idx="2">
                    <c:v>0.599082632</c:v>
                  </c:pt>
                  <c:pt idx="3">
                    <c:v>0.28919428300000005</c:v>
                  </c:pt>
                  <c:pt idx="4">
                    <c:v>0.53910419499999984</c:v>
                  </c:pt>
                </c:numCache>
              </c:numRef>
            </c:plus>
            <c:minus>
              <c:numRef>
                <c:f>'Refine data from Fld RI'!$AC$30:$AC$34</c:f>
                <c:numCache>
                  <c:formatCode>General</c:formatCode>
                  <c:ptCount val="5"/>
                  <c:pt idx="0">
                    <c:v>0.42712215300000006</c:v>
                  </c:pt>
                  <c:pt idx="1">
                    <c:v>0.41146081200000006</c:v>
                  </c:pt>
                  <c:pt idx="2">
                    <c:v>0.599082632</c:v>
                  </c:pt>
                  <c:pt idx="3">
                    <c:v>0.28919428300000005</c:v>
                  </c:pt>
                  <c:pt idx="4">
                    <c:v>0.53910419499999984</c:v>
                  </c:pt>
                </c:numCache>
              </c:numRef>
            </c:minus>
          </c:errBars>
          <c:cat>
            <c:strRef>
              <c:f>'Refine data from Fld RI'!$AA$30:$AA$34</c:f>
              <c:strCache>
                <c:ptCount val="5"/>
                <c:pt idx="0">
                  <c:v>Control</c:v>
                </c:pt>
                <c:pt idx="1">
                  <c:v>SMK 1:500</c:v>
                </c:pt>
                <c:pt idx="2">
                  <c:v>SMK 1:250</c:v>
                </c:pt>
                <c:pt idx="3">
                  <c:v>BGD 50:50</c:v>
                </c:pt>
                <c:pt idx="4">
                  <c:v>BGD 75:25</c:v>
                </c:pt>
              </c:strCache>
            </c:strRef>
          </c:cat>
          <c:val>
            <c:numRef>
              <c:f>'Refine data from Fld RI'!$AB$30:$AB$34</c:f>
              <c:numCache>
                <c:formatCode>General</c:formatCode>
                <c:ptCount val="5"/>
                <c:pt idx="0">
                  <c:v>2.963333333</c:v>
                </c:pt>
                <c:pt idx="1">
                  <c:v>3.3899999999999997</c:v>
                </c:pt>
                <c:pt idx="2">
                  <c:v>3.18</c:v>
                </c:pt>
                <c:pt idx="3">
                  <c:v>2.673333333</c:v>
                </c:pt>
                <c:pt idx="4">
                  <c:v>2.783333333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2E-4888-9C0E-C0841DC8F5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57945088"/>
        <c:axId val="58008320"/>
      </c:barChart>
      <c:catAx>
        <c:axId val="57945088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crossAx val="58008320"/>
        <c:crosses val="autoZero"/>
        <c:auto val="1"/>
        <c:lblAlgn val="ctr"/>
        <c:lblOffset val="100"/>
        <c:noMultiLvlLbl val="0"/>
      </c:catAx>
      <c:valAx>
        <c:axId val="580083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579450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Refined Data from Peat M'!$V$58:$V$62</c:f>
                <c:numCache>
                  <c:formatCode>General</c:formatCode>
                  <c:ptCount val="5"/>
                  <c:pt idx="0">
                    <c:v>1.0692680000000001</c:v>
                  </c:pt>
                  <c:pt idx="1">
                    <c:v>1.6370709999999999</c:v>
                  </c:pt>
                  <c:pt idx="2">
                    <c:v>3.0789610000000001</c:v>
                  </c:pt>
                  <c:pt idx="3">
                    <c:v>2.7537850000000001</c:v>
                  </c:pt>
                  <c:pt idx="4">
                    <c:v>3.6501139999999999</c:v>
                  </c:pt>
                </c:numCache>
              </c:numRef>
            </c:plus>
            <c:minus>
              <c:numRef>
                <c:f>'Refined Data from Peat M'!$V$58:$V$62</c:f>
                <c:numCache>
                  <c:formatCode>General</c:formatCode>
                  <c:ptCount val="5"/>
                  <c:pt idx="0">
                    <c:v>1.0692680000000001</c:v>
                  </c:pt>
                  <c:pt idx="1">
                    <c:v>1.6370709999999999</c:v>
                  </c:pt>
                  <c:pt idx="2">
                    <c:v>3.0789610000000001</c:v>
                  </c:pt>
                  <c:pt idx="3">
                    <c:v>2.7537850000000001</c:v>
                  </c:pt>
                  <c:pt idx="4">
                    <c:v>3.6501139999999999</c:v>
                  </c:pt>
                </c:numCache>
              </c:numRef>
            </c:minus>
          </c:errBars>
          <c:cat>
            <c:strRef>
              <c:f>'Refined Data from Peat M'!$T$58:$T$62</c:f>
              <c:strCache>
                <c:ptCount val="5"/>
                <c:pt idx="0">
                  <c:v>Control</c:v>
                </c:pt>
                <c:pt idx="1">
                  <c:v>SMK 1:500</c:v>
                </c:pt>
                <c:pt idx="2">
                  <c:v>SMK 1:250</c:v>
                </c:pt>
                <c:pt idx="3">
                  <c:v>BGD 50:50</c:v>
                </c:pt>
                <c:pt idx="4">
                  <c:v>BGD 75:25</c:v>
                </c:pt>
              </c:strCache>
            </c:strRef>
          </c:cat>
          <c:val>
            <c:numRef>
              <c:f>'Refined Data from Peat M'!$U$58:$U$62</c:f>
              <c:numCache>
                <c:formatCode>General</c:formatCode>
                <c:ptCount val="5"/>
                <c:pt idx="0">
                  <c:v>22.566669999999998</c:v>
                </c:pt>
                <c:pt idx="1">
                  <c:v>24.1</c:v>
                </c:pt>
                <c:pt idx="2">
                  <c:v>26.9</c:v>
                </c:pt>
                <c:pt idx="3">
                  <c:v>25.433330000000002</c:v>
                </c:pt>
                <c:pt idx="4">
                  <c:v>28.13333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B1-4FE7-AD2B-A5EB4776AB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63018112"/>
        <c:axId val="63020032"/>
      </c:barChart>
      <c:catAx>
        <c:axId val="63018112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crossAx val="63020032"/>
        <c:crosses val="autoZero"/>
        <c:auto val="1"/>
        <c:lblAlgn val="ctr"/>
        <c:lblOffset val="100"/>
        <c:noMultiLvlLbl val="0"/>
      </c:catAx>
      <c:valAx>
        <c:axId val="630200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630181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615125315217951"/>
          <c:y val="5.0774987586011261E-2"/>
          <c:w val="0.86509218516803066"/>
          <c:h val="0.74052636449289988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Refine data from Fld RI'!$AC$58:$AC$62</c:f>
                <c:numCache>
                  <c:formatCode>General</c:formatCode>
                  <c:ptCount val="5"/>
                  <c:pt idx="0">
                    <c:v>6.0827625300000001</c:v>
                  </c:pt>
                  <c:pt idx="1">
                    <c:v>4.5092497529999997</c:v>
                  </c:pt>
                  <c:pt idx="2">
                    <c:v>7.0945988849999999</c:v>
                  </c:pt>
                  <c:pt idx="3">
                    <c:v>4.1633319990000004</c:v>
                  </c:pt>
                  <c:pt idx="4">
                    <c:v>5.4650404090000002</c:v>
                  </c:pt>
                </c:numCache>
              </c:numRef>
            </c:plus>
            <c:minus>
              <c:numRef>
                <c:f>'Refine data from Fld RI'!$AC$58:$AC$62</c:f>
                <c:numCache>
                  <c:formatCode>General</c:formatCode>
                  <c:ptCount val="5"/>
                  <c:pt idx="0">
                    <c:v>6.0827625300000001</c:v>
                  </c:pt>
                  <c:pt idx="1">
                    <c:v>4.5092497529999997</c:v>
                  </c:pt>
                  <c:pt idx="2">
                    <c:v>7.0945988849999999</c:v>
                  </c:pt>
                  <c:pt idx="3">
                    <c:v>4.1633319990000004</c:v>
                  </c:pt>
                  <c:pt idx="4">
                    <c:v>5.4650404090000002</c:v>
                  </c:pt>
                </c:numCache>
              </c:numRef>
            </c:minus>
          </c:errBars>
          <c:cat>
            <c:strRef>
              <c:f>'Refine data from Fld RI'!$AA$58:$AA$62</c:f>
              <c:strCache>
                <c:ptCount val="5"/>
                <c:pt idx="0">
                  <c:v>Control</c:v>
                </c:pt>
                <c:pt idx="1">
                  <c:v>SMK 1:500</c:v>
                </c:pt>
                <c:pt idx="2">
                  <c:v>SMK 1:250</c:v>
                </c:pt>
                <c:pt idx="3">
                  <c:v>BGD 50:50</c:v>
                </c:pt>
                <c:pt idx="4">
                  <c:v>BGD 75:25</c:v>
                </c:pt>
              </c:strCache>
            </c:strRef>
          </c:cat>
          <c:val>
            <c:numRef>
              <c:f>'Refine data from Fld RI'!$AB$58:$AB$62</c:f>
              <c:numCache>
                <c:formatCode>General</c:formatCode>
                <c:ptCount val="5"/>
                <c:pt idx="0">
                  <c:v>90</c:v>
                </c:pt>
                <c:pt idx="1">
                  <c:v>97.333333330000002</c:v>
                </c:pt>
                <c:pt idx="2">
                  <c:v>93.333333330000002</c:v>
                </c:pt>
                <c:pt idx="3">
                  <c:v>96.666666669999998</c:v>
                </c:pt>
                <c:pt idx="4">
                  <c:v>95.33333333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1D-4B33-B2A7-4398BD034B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109436288"/>
        <c:axId val="119391360"/>
      </c:barChart>
      <c:catAx>
        <c:axId val="109436288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crossAx val="119391360"/>
        <c:crosses val="autoZero"/>
        <c:auto val="1"/>
        <c:lblAlgn val="ctr"/>
        <c:lblOffset val="100"/>
        <c:noMultiLvlLbl val="0"/>
      </c:catAx>
      <c:valAx>
        <c:axId val="1193913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094362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409693273634912"/>
          <c:y val="2.8252405949256338E-2"/>
          <c:w val="0.84397740723586023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Refine data from Fld RI'!$AC$142:$AC$146</c:f>
                <c:numCache>
                  <c:formatCode>General</c:formatCode>
                  <c:ptCount val="5"/>
                  <c:pt idx="0">
                    <c:v>58.44714621</c:v>
                  </c:pt>
                  <c:pt idx="1">
                    <c:v>39.390835230000008</c:v>
                  </c:pt>
                  <c:pt idx="2">
                    <c:v>70.191233069999996</c:v>
                  </c:pt>
                  <c:pt idx="3">
                    <c:v>64.735043320000003</c:v>
                  </c:pt>
                  <c:pt idx="4">
                    <c:v>71.678119580000001</c:v>
                  </c:pt>
                </c:numCache>
              </c:numRef>
            </c:plus>
            <c:minus>
              <c:numRef>
                <c:f>'Refine data from Fld RI'!$AC$142:$AC$146</c:f>
                <c:numCache>
                  <c:formatCode>General</c:formatCode>
                  <c:ptCount val="5"/>
                  <c:pt idx="0">
                    <c:v>58.44714621</c:v>
                  </c:pt>
                  <c:pt idx="1">
                    <c:v>39.390835230000008</c:v>
                  </c:pt>
                  <c:pt idx="2">
                    <c:v>70.191233069999996</c:v>
                  </c:pt>
                  <c:pt idx="3">
                    <c:v>64.735043320000003</c:v>
                  </c:pt>
                  <c:pt idx="4">
                    <c:v>71.678119580000001</c:v>
                  </c:pt>
                </c:numCache>
              </c:numRef>
            </c:minus>
          </c:errBars>
          <c:cat>
            <c:strRef>
              <c:f>'Refine data from Fld RI'!$AA$142:$AA$146</c:f>
              <c:strCache>
                <c:ptCount val="5"/>
                <c:pt idx="0">
                  <c:v>Control</c:v>
                </c:pt>
                <c:pt idx="1">
                  <c:v>SMK 1:500</c:v>
                </c:pt>
                <c:pt idx="2">
                  <c:v>SMK 1:250</c:v>
                </c:pt>
                <c:pt idx="3">
                  <c:v>BGD 50:50</c:v>
                </c:pt>
                <c:pt idx="4">
                  <c:v>BGD 75:25</c:v>
                </c:pt>
              </c:strCache>
            </c:strRef>
          </c:cat>
          <c:val>
            <c:numRef>
              <c:f>'Refine data from Fld RI'!$AB$142:$AB$146</c:f>
              <c:numCache>
                <c:formatCode>General</c:formatCode>
                <c:ptCount val="5"/>
                <c:pt idx="0">
                  <c:v>247.93</c:v>
                </c:pt>
                <c:pt idx="1">
                  <c:v>495.88</c:v>
                </c:pt>
                <c:pt idx="2">
                  <c:v>443.18</c:v>
                </c:pt>
                <c:pt idx="3">
                  <c:v>388.13666669999998</c:v>
                </c:pt>
                <c:pt idx="4">
                  <c:v>473.5966666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5B-4538-9AEB-0F38E50FBF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58098432"/>
        <c:axId val="58099968"/>
      </c:barChart>
      <c:catAx>
        <c:axId val="58098432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ln w="19050">
            <a:solidFill>
              <a:schemeClr val="tx1"/>
            </a:solidFill>
          </a:ln>
        </c:spPr>
        <c:crossAx val="58099968"/>
        <c:crosses val="autoZero"/>
        <c:auto val="1"/>
        <c:lblAlgn val="ctr"/>
        <c:lblOffset val="100"/>
        <c:noMultiLvlLbl val="0"/>
      </c:catAx>
      <c:valAx>
        <c:axId val="580999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580984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743ACE-54EE-495B-9CCB-973479843DD6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6800" y="1143000"/>
            <a:ext cx="2184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75065A-2640-4EC4-B398-2420B5E338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6922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rrect Units addition need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75065A-2640-4EC4-B398-2420B5E3386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727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5" y="3320411"/>
            <a:ext cx="6428422" cy="229112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4429" y="6056896"/>
            <a:ext cx="5293995" cy="273154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14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28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42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56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702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842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1982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123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757483" y="457733"/>
            <a:ext cx="1786985" cy="972616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6527" y="457733"/>
            <a:ext cx="5234911" cy="972616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4" y="3320407"/>
            <a:ext cx="6428423" cy="229113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4428" y="6056895"/>
            <a:ext cx="5293995" cy="273154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80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61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421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228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035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842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649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0456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80886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88258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7413" y="6868441"/>
            <a:ext cx="6428423" cy="2122882"/>
          </a:xfrm>
        </p:spPr>
        <p:txBody>
          <a:bodyPr anchor="t"/>
          <a:lstStyle>
            <a:lvl1pPr algn="l">
              <a:defRPr sz="330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413" y="4530303"/>
            <a:ext cx="6428423" cy="2338138"/>
          </a:xfrm>
        </p:spPr>
        <p:txBody>
          <a:bodyPr anchor="b"/>
          <a:lstStyle>
            <a:lvl1pPr marL="0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1pPr>
            <a:lvl2pPr marL="380700" indent="0">
              <a:buNone/>
              <a:defRPr sz="1497">
                <a:solidFill>
                  <a:schemeClr val="tx1">
                    <a:tint val="75000"/>
                  </a:schemeClr>
                </a:solidFill>
              </a:defRPr>
            </a:lvl2pPr>
            <a:lvl3pPr marL="761400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3pPr>
            <a:lvl4pPr marL="1142100" indent="0">
              <a:buNone/>
              <a:defRPr sz="1182">
                <a:solidFill>
                  <a:schemeClr val="tx1">
                    <a:tint val="75000"/>
                  </a:schemeClr>
                </a:solidFill>
              </a:defRPr>
            </a:lvl4pPr>
            <a:lvl5pPr marL="1522801" indent="0">
              <a:buNone/>
              <a:defRPr sz="1182">
                <a:solidFill>
                  <a:schemeClr val="tx1">
                    <a:tint val="75000"/>
                  </a:schemeClr>
                </a:solidFill>
              </a:defRPr>
            </a:lvl5pPr>
            <a:lvl6pPr marL="1903501" indent="0">
              <a:buNone/>
              <a:defRPr sz="1182">
                <a:solidFill>
                  <a:schemeClr val="tx1">
                    <a:tint val="75000"/>
                  </a:schemeClr>
                </a:solidFill>
              </a:defRPr>
            </a:lvl6pPr>
            <a:lvl7pPr marL="2284202" indent="0">
              <a:buNone/>
              <a:defRPr sz="1182">
                <a:solidFill>
                  <a:schemeClr val="tx1">
                    <a:tint val="75000"/>
                  </a:schemeClr>
                </a:solidFill>
              </a:defRPr>
            </a:lvl7pPr>
            <a:lvl8pPr marL="2664902" indent="0">
              <a:buNone/>
              <a:defRPr sz="1182">
                <a:solidFill>
                  <a:schemeClr val="tx1">
                    <a:tint val="75000"/>
                  </a:schemeClr>
                </a:solidFill>
              </a:defRPr>
            </a:lvl8pPr>
            <a:lvl9pPr marL="3045602" indent="0">
              <a:buNone/>
              <a:defRPr sz="118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84896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8142" y="2494016"/>
            <a:ext cx="3340259" cy="7054007"/>
          </a:xfrm>
        </p:spPr>
        <p:txBody>
          <a:bodyPr/>
          <a:lstStyle>
            <a:lvl1pPr>
              <a:defRPr sz="2363"/>
            </a:lvl1pPr>
            <a:lvl2pPr>
              <a:defRPr sz="1969"/>
            </a:lvl2pPr>
            <a:lvl3pPr>
              <a:defRPr sz="1654"/>
            </a:lvl3pPr>
            <a:lvl4pPr>
              <a:defRPr sz="1497"/>
            </a:lvl4pPr>
            <a:lvl5pPr>
              <a:defRPr sz="1497"/>
            </a:lvl5pPr>
            <a:lvl6pPr>
              <a:defRPr sz="1497"/>
            </a:lvl6pPr>
            <a:lvl7pPr>
              <a:defRPr sz="1497"/>
            </a:lvl7pPr>
            <a:lvl8pPr>
              <a:defRPr sz="1497"/>
            </a:lvl8pPr>
            <a:lvl9pPr>
              <a:defRPr sz="149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4449" y="2494016"/>
            <a:ext cx="3340259" cy="7054007"/>
          </a:xfrm>
        </p:spPr>
        <p:txBody>
          <a:bodyPr/>
          <a:lstStyle>
            <a:lvl1pPr>
              <a:defRPr sz="2363"/>
            </a:lvl1pPr>
            <a:lvl2pPr>
              <a:defRPr sz="1969"/>
            </a:lvl2pPr>
            <a:lvl3pPr>
              <a:defRPr sz="1654"/>
            </a:lvl3pPr>
            <a:lvl4pPr>
              <a:defRPr sz="1497"/>
            </a:lvl4pPr>
            <a:lvl5pPr>
              <a:defRPr sz="1497"/>
            </a:lvl5pPr>
            <a:lvl6pPr>
              <a:defRPr sz="1497"/>
            </a:lvl6pPr>
            <a:lvl7pPr>
              <a:defRPr sz="1497"/>
            </a:lvl7pPr>
            <a:lvl8pPr>
              <a:defRPr sz="1497"/>
            </a:lvl8pPr>
            <a:lvl9pPr>
              <a:defRPr sz="149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7082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143" y="2392574"/>
            <a:ext cx="3341572" cy="997111"/>
          </a:xfrm>
        </p:spPr>
        <p:txBody>
          <a:bodyPr anchor="b"/>
          <a:lstStyle>
            <a:lvl1pPr marL="0" indent="0">
              <a:buNone/>
              <a:defRPr sz="1969" b="1"/>
            </a:lvl1pPr>
            <a:lvl2pPr marL="380700" indent="0">
              <a:buNone/>
              <a:defRPr sz="1654" b="1"/>
            </a:lvl2pPr>
            <a:lvl3pPr marL="761400" indent="0">
              <a:buNone/>
              <a:defRPr sz="1497" b="1"/>
            </a:lvl3pPr>
            <a:lvl4pPr marL="1142100" indent="0">
              <a:buNone/>
              <a:defRPr sz="1339" b="1"/>
            </a:lvl4pPr>
            <a:lvl5pPr marL="1522801" indent="0">
              <a:buNone/>
              <a:defRPr sz="1339" b="1"/>
            </a:lvl5pPr>
            <a:lvl6pPr marL="1903501" indent="0">
              <a:buNone/>
              <a:defRPr sz="1339" b="1"/>
            </a:lvl6pPr>
            <a:lvl7pPr marL="2284202" indent="0">
              <a:buNone/>
              <a:defRPr sz="1339" b="1"/>
            </a:lvl7pPr>
            <a:lvl8pPr marL="2664902" indent="0">
              <a:buNone/>
              <a:defRPr sz="1339" b="1"/>
            </a:lvl8pPr>
            <a:lvl9pPr marL="3045602" indent="0">
              <a:buNone/>
              <a:defRPr sz="133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8143" y="3389685"/>
            <a:ext cx="3341572" cy="6158338"/>
          </a:xfrm>
        </p:spPr>
        <p:txBody>
          <a:bodyPr/>
          <a:lstStyle>
            <a:lvl1pPr>
              <a:defRPr sz="1969"/>
            </a:lvl1pPr>
            <a:lvl2pPr>
              <a:defRPr sz="1654"/>
            </a:lvl2pPr>
            <a:lvl3pPr>
              <a:defRPr sz="1497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1823" y="2392574"/>
            <a:ext cx="3342885" cy="997111"/>
          </a:xfrm>
        </p:spPr>
        <p:txBody>
          <a:bodyPr anchor="b"/>
          <a:lstStyle>
            <a:lvl1pPr marL="0" indent="0">
              <a:buNone/>
              <a:defRPr sz="1969" b="1"/>
            </a:lvl1pPr>
            <a:lvl2pPr marL="380700" indent="0">
              <a:buNone/>
              <a:defRPr sz="1654" b="1"/>
            </a:lvl2pPr>
            <a:lvl3pPr marL="761400" indent="0">
              <a:buNone/>
              <a:defRPr sz="1497" b="1"/>
            </a:lvl3pPr>
            <a:lvl4pPr marL="1142100" indent="0">
              <a:buNone/>
              <a:defRPr sz="1339" b="1"/>
            </a:lvl4pPr>
            <a:lvl5pPr marL="1522801" indent="0">
              <a:buNone/>
              <a:defRPr sz="1339" b="1"/>
            </a:lvl5pPr>
            <a:lvl6pPr marL="1903501" indent="0">
              <a:buNone/>
              <a:defRPr sz="1339" b="1"/>
            </a:lvl6pPr>
            <a:lvl7pPr marL="2284202" indent="0">
              <a:buNone/>
              <a:defRPr sz="1339" b="1"/>
            </a:lvl7pPr>
            <a:lvl8pPr marL="2664902" indent="0">
              <a:buNone/>
              <a:defRPr sz="1339" b="1"/>
            </a:lvl8pPr>
            <a:lvl9pPr marL="3045602" indent="0">
              <a:buNone/>
              <a:defRPr sz="133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1823" y="3389685"/>
            <a:ext cx="3342885" cy="6158338"/>
          </a:xfrm>
        </p:spPr>
        <p:txBody>
          <a:bodyPr/>
          <a:lstStyle>
            <a:lvl1pPr>
              <a:defRPr sz="1969"/>
            </a:lvl1pPr>
            <a:lvl2pPr>
              <a:defRPr sz="1654"/>
            </a:lvl2pPr>
            <a:lvl3pPr>
              <a:defRPr sz="1497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99958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02032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84881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143" y="425566"/>
            <a:ext cx="2488126" cy="1811130"/>
          </a:xfrm>
        </p:spPr>
        <p:txBody>
          <a:bodyPr anchor="b"/>
          <a:lstStyle>
            <a:lvl1pPr algn="l">
              <a:defRPr sz="165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6864" y="425568"/>
            <a:ext cx="4227844" cy="9122457"/>
          </a:xfrm>
        </p:spPr>
        <p:txBody>
          <a:bodyPr/>
          <a:lstStyle>
            <a:lvl1pPr>
              <a:defRPr sz="2678"/>
            </a:lvl1pPr>
            <a:lvl2pPr>
              <a:defRPr sz="2363"/>
            </a:lvl2pPr>
            <a:lvl3pPr>
              <a:defRPr sz="1969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8143" y="2236698"/>
            <a:ext cx="2488126" cy="7311327"/>
          </a:xfrm>
        </p:spPr>
        <p:txBody>
          <a:bodyPr/>
          <a:lstStyle>
            <a:lvl1pPr marL="0" indent="0">
              <a:buNone/>
              <a:defRPr sz="1182"/>
            </a:lvl1pPr>
            <a:lvl2pPr marL="380700" indent="0">
              <a:buNone/>
              <a:defRPr sz="1024"/>
            </a:lvl2pPr>
            <a:lvl3pPr marL="761400" indent="0">
              <a:buNone/>
              <a:defRPr sz="866"/>
            </a:lvl3pPr>
            <a:lvl4pPr marL="1142100" indent="0">
              <a:buNone/>
              <a:defRPr sz="788"/>
            </a:lvl4pPr>
            <a:lvl5pPr marL="1522801" indent="0">
              <a:buNone/>
              <a:defRPr sz="788"/>
            </a:lvl5pPr>
            <a:lvl6pPr marL="1903501" indent="0">
              <a:buNone/>
              <a:defRPr sz="788"/>
            </a:lvl6pPr>
            <a:lvl7pPr marL="2284202" indent="0">
              <a:buNone/>
              <a:defRPr sz="788"/>
            </a:lvl7pPr>
            <a:lvl8pPr marL="2664902" indent="0">
              <a:buNone/>
              <a:defRPr sz="788"/>
            </a:lvl8pPr>
            <a:lvl9pPr marL="3045602" indent="0">
              <a:buNone/>
              <a:defRPr sz="78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657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2371" y="7482047"/>
            <a:ext cx="4537710" cy="883299"/>
          </a:xfrm>
        </p:spPr>
        <p:txBody>
          <a:bodyPr anchor="b"/>
          <a:lstStyle>
            <a:lvl1pPr algn="l">
              <a:defRPr sz="165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2371" y="955050"/>
            <a:ext cx="4537710" cy="6413183"/>
          </a:xfrm>
        </p:spPr>
        <p:txBody>
          <a:bodyPr/>
          <a:lstStyle>
            <a:lvl1pPr marL="0" indent="0">
              <a:buNone/>
              <a:defRPr sz="2678"/>
            </a:lvl1pPr>
            <a:lvl2pPr marL="380700" indent="0">
              <a:buNone/>
              <a:defRPr sz="2363"/>
            </a:lvl2pPr>
            <a:lvl3pPr marL="761400" indent="0">
              <a:buNone/>
              <a:defRPr sz="1969"/>
            </a:lvl3pPr>
            <a:lvl4pPr marL="1142100" indent="0">
              <a:buNone/>
              <a:defRPr sz="1654"/>
            </a:lvl4pPr>
            <a:lvl5pPr marL="1522801" indent="0">
              <a:buNone/>
              <a:defRPr sz="1654"/>
            </a:lvl5pPr>
            <a:lvl6pPr marL="1903501" indent="0">
              <a:buNone/>
              <a:defRPr sz="1654"/>
            </a:lvl6pPr>
            <a:lvl7pPr marL="2284202" indent="0">
              <a:buNone/>
              <a:defRPr sz="1654"/>
            </a:lvl7pPr>
            <a:lvl8pPr marL="2664902" indent="0">
              <a:buNone/>
              <a:defRPr sz="1654"/>
            </a:lvl8pPr>
            <a:lvl9pPr marL="3045602" indent="0">
              <a:buNone/>
              <a:defRPr sz="165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2371" y="8365346"/>
            <a:ext cx="4537710" cy="1254429"/>
          </a:xfrm>
        </p:spPr>
        <p:txBody>
          <a:bodyPr/>
          <a:lstStyle>
            <a:lvl1pPr marL="0" indent="0">
              <a:buNone/>
              <a:defRPr sz="1182"/>
            </a:lvl1pPr>
            <a:lvl2pPr marL="380700" indent="0">
              <a:buNone/>
              <a:defRPr sz="1024"/>
            </a:lvl2pPr>
            <a:lvl3pPr marL="761400" indent="0">
              <a:buNone/>
              <a:defRPr sz="866"/>
            </a:lvl3pPr>
            <a:lvl4pPr marL="1142100" indent="0">
              <a:buNone/>
              <a:defRPr sz="788"/>
            </a:lvl4pPr>
            <a:lvl5pPr marL="1522801" indent="0">
              <a:buNone/>
              <a:defRPr sz="788"/>
            </a:lvl5pPr>
            <a:lvl6pPr marL="1903501" indent="0">
              <a:buNone/>
              <a:defRPr sz="788"/>
            </a:lvl6pPr>
            <a:lvl7pPr marL="2284202" indent="0">
              <a:buNone/>
              <a:defRPr sz="788"/>
            </a:lvl7pPr>
            <a:lvl8pPr marL="2664902" indent="0">
              <a:buNone/>
              <a:defRPr sz="788"/>
            </a:lvl8pPr>
            <a:lvl9pPr marL="3045602" indent="0">
              <a:buNone/>
              <a:defRPr sz="78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82053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45754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83066" y="428043"/>
            <a:ext cx="1701641" cy="91199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8143" y="428043"/>
            <a:ext cx="4978876" cy="91199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114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7414" y="6868444"/>
            <a:ext cx="6428422" cy="2122882"/>
          </a:xfrm>
        </p:spPr>
        <p:txBody>
          <a:bodyPr anchor="t"/>
          <a:lstStyle>
            <a:lvl1pPr algn="l">
              <a:defRPr sz="274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414" y="4530306"/>
            <a:ext cx="6428422" cy="2338139"/>
          </a:xfrm>
        </p:spPr>
        <p:txBody>
          <a:bodyPr anchor="b"/>
          <a:lstStyle>
            <a:lvl1pPr marL="0" indent="0">
              <a:buNone/>
              <a:defRPr sz="1374">
                <a:solidFill>
                  <a:schemeClr val="tx1">
                    <a:tint val="75000"/>
                  </a:schemeClr>
                </a:solidFill>
              </a:defRPr>
            </a:lvl1pPr>
            <a:lvl2pPr marL="314040" indent="0">
              <a:buNone/>
              <a:defRPr sz="1237">
                <a:solidFill>
                  <a:schemeClr val="tx1">
                    <a:tint val="75000"/>
                  </a:schemeClr>
                </a:solidFill>
              </a:defRPr>
            </a:lvl2pPr>
            <a:lvl3pPr marL="628081" indent="0">
              <a:buNone/>
              <a:defRPr sz="1099">
                <a:solidFill>
                  <a:schemeClr val="tx1">
                    <a:tint val="75000"/>
                  </a:schemeClr>
                </a:solidFill>
              </a:defRPr>
            </a:lvl3pPr>
            <a:lvl4pPr marL="942120" indent="0">
              <a:buNone/>
              <a:defRPr sz="962">
                <a:solidFill>
                  <a:schemeClr val="tx1">
                    <a:tint val="75000"/>
                  </a:schemeClr>
                </a:solidFill>
              </a:defRPr>
            </a:lvl4pPr>
            <a:lvl5pPr marL="1256162" indent="0">
              <a:buNone/>
              <a:defRPr sz="962">
                <a:solidFill>
                  <a:schemeClr val="tx1">
                    <a:tint val="75000"/>
                  </a:schemeClr>
                </a:solidFill>
              </a:defRPr>
            </a:lvl5pPr>
            <a:lvl6pPr marL="1570202" indent="0">
              <a:buNone/>
              <a:defRPr sz="962">
                <a:solidFill>
                  <a:schemeClr val="tx1">
                    <a:tint val="75000"/>
                  </a:schemeClr>
                </a:solidFill>
              </a:defRPr>
            </a:lvl6pPr>
            <a:lvl7pPr marL="1884243" indent="0">
              <a:buNone/>
              <a:defRPr sz="962">
                <a:solidFill>
                  <a:schemeClr val="tx1">
                    <a:tint val="75000"/>
                  </a:schemeClr>
                </a:solidFill>
              </a:defRPr>
            </a:lvl7pPr>
            <a:lvl8pPr marL="2198283" indent="0">
              <a:buNone/>
              <a:defRPr sz="962">
                <a:solidFill>
                  <a:schemeClr val="tx1">
                    <a:tint val="75000"/>
                  </a:schemeClr>
                </a:solidFill>
              </a:defRPr>
            </a:lvl8pPr>
            <a:lvl9pPr marL="2512323" indent="0">
              <a:buNone/>
              <a:defRPr sz="96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6527" y="2659790"/>
            <a:ext cx="3510949" cy="7524108"/>
          </a:xfrm>
        </p:spPr>
        <p:txBody>
          <a:bodyPr/>
          <a:lstStyle>
            <a:lvl1pPr>
              <a:defRPr sz="1924"/>
            </a:lvl1pPr>
            <a:lvl2pPr>
              <a:defRPr sz="1649"/>
            </a:lvl2pPr>
            <a:lvl3pPr>
              <a:defRPr sz="1374"/>
            </a:lvl3pPr>
            <a:lvl4pPr>
              <a:defRPr sz="1237"/>
            </a:lvl4pPr>
            <a:lvl5pPr>
              <a:defRPr sz="1237"/>
            </a:lvl5pPr>
            <a:lvl6pPr>
              <a:defRPr sz="1237"/>
            </a:lvl6pPr>
            <a:lvl7pPr>
              <a:defRPr sz="1237"/>
            </a:lvl7pPr>
            <a:lvl8pPr>
              <a:defRPr sz="1237"/>
            </a:lvl8pPr>
            <a:lvl9pPr>
              <a:defRPr sz="123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33519" y="2659790"/>
            <a:ext cx="3510949" cy="7524108"/>
          </a:xfrm>
        </p:spPr>
        <p:txBody>
          <a:bodyPr/>
          <a:lstStyle>
            <a:lvl1pPr>
              <a:defRPr sz="1924"/>
            </a:lvl1pPr>
            <a:lvl2pPr>
              <a:defRPr sz="1649"/>
            </a:lvl2pPr>
            <a:lvl3pPr>
              <a:defRPr sz="1374"/>
            </a:lvl3pPr>
            <a:lvl4pPr>
              <a:defRPr sz="1237"/>
            </a:lvl4pPr>
            <a:lvl5pPr>
              <a:defRPr sz="1237"/>
            </a:lvl5pPr>
            <a:lvl6pPr>
              <a:defRPr sz="1237"/>
            </a:lvl6pPr>
            <a:lvl7pPr>
              <a:defRPr sz="1237"/>
            </a:lvl7pPr>
            <a:lvl8pPr>
              <a:defRPr sz="1237"/>
            </a:lvl8pPr>
            <a:lvl9pPr>
              <a:defRPr sz="123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143" y="428041"/>
            <a:ext cx="6806565" cy="178144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143" y="2392577"/>
            <a:ext cx="3341572" cy="997111"/>
          </a:xfrm>
        </p:spPr>
        <p:txBody>
          <a:bodyPr anchor="b"/>
          <a:lstStyle>
            <a:lvl1pPr marL="0" indent="0">
              <a:buNone/>
              <a:defRPr sz="1649" b="1"/>
            </a:lvl1pPr>
            <a:lvl2pPr marL="314040" indent="0">
              <a:buNone/>
              <a:defRPr sz="1374" b="1"/>
            </a:lvl2pPr>
            <a:lvl3pPr marL="628081" indent="0">
              <a:buNone/>
              <a:defRPr sz="1237" b="1"/>
            </a:lvl3pPr>
            <a:lvl4pPr marL="942120" indent="0">
              <a:buNone/>
              <a:defRPr sz="1099" b="1"/>
            </a:lvl4pPr>
            <a:lvl5pPr marL="1256162" indent="0">
              <a:buNone/>
              <a:defRPr sz="1099" b="1"/>
            </a:lvl5pPr>
            <a:lvl6pPr marL="1570202" indent="0">
              <a:buNone/>
              <a:defRPr sz="1099" b="1"/>
            </a:lvl6pPr>
            <a:lvl7pPr marL="1884243" indent="0">
              <a:buNone/>
              <a:defRPr sz="1099" b="1"/>
            </a:lvl7pPr>
            <a:lvl8pPr marL="2198283" indent="0">
              <a:buNone/>
              <a:defRPr sz="1099" b="1"/>
            </a:lvl8pPr>
            <a:lvl9pPr marL="2512323" indent="0">
              <a:buNone/>
              <a:defRPr sz="109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8143" y="3389687"/>
            <a:ext cx="3341572" cy="6158339"/>
          </a:xfrm>
        </p:spPr>
        <p:txBody>
          <a:bodyPr/>
          <a:lstStyle>
            <a:lvl1pPr>
              <a:defRPr sz="1649"/>
            </a:lvl1pPr>
            <a:lvl2pPr>
              <a:defRPr sz="1374"/>
            </a:lvl2pPr>
            <a:lvl3pPr>
              <a:defRPr sz="1237"/>
            </a:lvl3pPr>
            <a:lvl4pPr>
              <a:defRPr sz="1099"/>
            </a:lvl4pPr>
            <a:lvl5pPr>
              <a:defRPr sz="1099"/>
            </a:lvl5pPr>
            <a:lvl6pPr>
              <a:defRPr sz="1099"/>
            </a:lvl6pPr>
            <a:lvl7pPr>
              <a:defRPr sz="1099"/>
            </a:lvl7pPr>
            <a:lvl8pPr>
              <a:defRPr sz="1099"/>
            </a:lvl8pPr>
            <a:lvl9pPr>
              <a:defRPr sz="10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1826" y="2392577"/>
            <a:ext cx="3342884" cy="997111"/>
          </a:xfrm>
        </p:spPr>
        <p:txBody>
          <a:bodyPr anchor="b"/>
          <a:lstStyle>
            <a:lvl1pPr marL="0" indent="0">
              <a:buNone/>
              <a:defRPr sz="1649" b="1"/>
            </a:lvl1pPr>
            <a:lvl2pPr marL="314040" indent="0">
              <a:buNone/>
              <a:defRPr sz="1374" b="1"/>
            </a:lvl2pPr>
            <a:lvl3pPr marL="628081" indent="0">
              <a:buNone/>
              <a:defRPr sz="1237" b="1"/>
            </a:lvl3pPr>
            <a:lvl4pPr marL="942120" indent="0">
              <a:buNone/>
              <a:defRPr sz="1099" b="1"/>
            </a:lvl4pPr>
            <a:lvl5pPr marL="1256162" indent="0">
              <a:buNone/>
              <a:defRPr sz="1099" b="1"/>
            </a:lvl5pPr>
            <a:lvl6pPr marL="1570202" indent="0">
              <a:buNone/>
              <a:defRPr sz="1099" b="1"/>
            </a:lvl6pPr>
            <a:lvl7pPr marL="1884243" indent="0">
              <a:buNone/>
              <a:defRPr sz="1099" b="1"/>
            </a:lvl7pPr>
            <a:lvl8pPr marL="2198283" indent="0">
              <a:buNone/>
              <a:defRPr sz="1099" b="1"/>
            </a:lvl8pPr>
            <a:lvl9pPr marL="2512323" indent="0">
              <a:buNone/>
              <a:defRPr sz="109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1826" y="3389687"/>
            <a:ext cx="3342884" cy="6158339"/>
          </a:xfrm>
        </p:spPr>
        <p:txBody>
          <a:bodyPr/>
          <a:lstStyle>
            <a:lvl1pPr>
              <a:defRPr sz="1649"/>
            </a:lvl1pPr>
            <a:lvl2pPr>
              <a:defRPr sz="1374"/>
            </a:lvl2pPr>
            <a:lvl3pPr>
              <a:defRPr sz="1237"/>
            </a:lvl3pPr>
            <a:lvl4pPr>
              <a:defRPr sz="1099"/>
            </a:lvl4pPr>
            <a:lvl5pPr>
              <a:defRPr sz="1099"/>
            </a:lvl5pPr>
            <a:lvl6pPr>
              <a:defRPr sz="1099"/>
            </a:lvl6pPr>
            <a:lvl7pPr>
              <a:defRPr sz="1099"/>
            </a:lvl7pPr>
            <a:lvl8pPr>
              <a:defRPr sz="1099"/>
            </a:lvl8pPr>
            <a:lvl9pPr>
              <a:defRPr sz="10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144" y="425566"/>
            <a:ext cx="2488126" cy="1811130"/>
          </a:xfrm>
        </p:spPr>
        <p:txBody>
          <a:bodyPr anchor="b"/>
          <a:lstStyle>
            <a:lvl1pPr algn="l">
              <a:defRPr sz="137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6864" y="425570"/>
            <a:ext cx="4227843" cy="9122456"/>
          </a:xfrm>
        </p:spPr>
        <p:txBody>
          <a:bodyPr/>
          <a:lstStyle>
            <a:lvl1pPr>
              <a:defRPr sz="2198"/>
            </a:lvl1pPr>
            <a:lvl2pPr>
              <a:defRPr sz="1924"/>
            </a:lvl2pPr>
            <a:lvl3pPr>
              <a:defRPr sz="1649"/>
            </a:lvl3pPr>
            <a:lvl4pPr>
              <a:defRPr sz="1374"/>
            </a:lvl4pPr>
            <a:lvl5pPr>
              <a:defRPr sz="1374"/>
            </a:lvl5pPr>
            <a:lvl6pPr>
              <a:defRPr sz="1374"/>
            </a:lvl6pPr>
            <a:lvl7pPr>
              <a:defRPr sz="1374"/>
            </a:lvl7pPr>
            <a:lvl8pPr>
              <a:defRPr sz="1374"/>
            </a:lvl8pPr>
            <a:lvl9pPr>
              <a:defRPr sz="137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8144" y="2236700"/>
            <a:ext cx="2488126" cy="7311326"/>
          </a:xfrm>
        </p:spPr>
        <p:txBody>
          <a:bodyPr/>
          <a:lstStyle>
            <a:lvl1pPr marL="0" indent="0">
              <a:buNone/>
              <a:defRPr sz="962"/>
            </a:lvl1pPr>
            <a:lvl2pPr marL="314040" indent="0">
              <a:buNone/>
              <a:defRPr sz="824"/>
            </a:lvl2pPr>
            <a:lvl3pPr marL="628081" indent="0">
              <a:buNone/>
              <a:defRPr sz="687"/>
            </a:lvl3pPr>
            <a:lvl4pPr marL="942120" indent="0">
              <a:buNone/>
              <a:defRPr sz="618"/>
            </a:lvl4pPr>
            <a:lvl5pPr marL="1256162" indent="0">
              <a:buNone/>
              <a:defRPr sz="618"/>
            </a:lvl5pPr>
            <a:lvl6pPr marL="1570202" indent="0">
              <a:buNone/>
              <a:defRPr sz="618"/>
            </a:lvl6pPr>
            <a:lvl7pPr marL="1884243" indent="0">
              <a:buNone/>
              <a:defRPr sz="618"/>
            </a:lvl7pPr>
            <a:lvl8pPr marL="2198283" indent="0">
              <a:buNone/>
              <a:defRPr sz="618"/>
            </a:lvl8pPr>
            <a:lvl9pPr marL="2512323" indent="0">
              <a:buNone/>
              <a:defRPr sz="61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2373" y="7482050"/>
            <a:ext cx="4537710" cy="883298"/>
          </a:xfrm>
        </p:spPr>
        <p:txBody>
          <a:bodyPr anchor="b"/>
          <a:lstStyle>
            <a:lvl1pPr algn="l">
              <a:defRPr sz="137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2373" y="955050"/>
            <a:ext cx="4537710" cy="6413183"/>
          </a:xfrm>
        </p:spPr>
        <p:txBody>
          <a:bodyPr/>
          <a:lstStyle>
            <a:lvl1pPr marL="0" indent="0">
              <a:buNone/>
              <a:defRPr sz="2198"/>
            </a:lvl1pPr>
            <a:lvl2pPr marL="314040" indent="0">
              <a:buNone/>
              <a:defRPr sz="1924"/>
            </a:lvl2pPr>
            <a:lvl3pPr marL="628081" indent="0">
              <a:buNone/>
              <a:defRPr sz="1649"/>
            </a:lvl3pPr>
            <a:lvl4pPr marL="942120" indent="0">
              <a:buNone/>
              <a:defRPr sz="1374"/>
            </a:lvl4pPr>
            <a:lvl5pPr marL="1256162" indent="0">
              <a:buNone/>
              <a:defRPr sz="1374"/>
            </a:lvl5pPr>
            <a:lvl6pPr marL="1570202" indent="0">
              <a:buNone/>
              <a:defRPr sz="1374"/>
            </a:lvl6pPr>
            <a:lvl7pPr marL="1884243" indent="0">
              <a:buNone/>
              <a:defRPr sz="1374"/>
            </a:lvl7pPr>
            <a:lvl8pPr marL="2198283" indent="0">
              <a:buNone/>
              <a:defRPr sz="1374"/>
            </a:lvl8pPr>
            <a:lvl9pPr marL="2512323" indent="0">
              <a:buNone/>
              <a:defRPr sz="137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2373" y="8365347"/>
            <a:ext cx="4537710" cy="1254430"/>
          </a:xfrm>
        </p:spPr>
        <p:txBody>
          <a:bodyPr/>
          <a:lstStyle>
            <a:lvl1pPr marL="0" indent="0">
              <a:buNone/>
              <a:defRPr sz="962"/>
            </a:lvl1pPr>
            <a:lvl2pPr marL="314040" indent="0">
              <a:buNone/>
              <a:defRPr sz="824"/>
            </a:lvl2pPr>
            <a:lvl3pPr marL="628081" indent="0">
              <a:buNone/>
              <a:defRPr sz="687"/>
            </a:lvl3pPr>
            <a:lvl4pPr marL="942120" indent="0">
              <a:buNone/>
              <a:defRPr sz="618"/>
            </a:lvl4pPr>
            <a:lvl5pPr marL="1256162" indent="0">
              <a:buNone/>
              <a:defRPr sz="618"/>
            </a:lvl5pPr>
            <a:lvl6pPr marL="1570202" indent="0">
              <a:buNone/>
              <a:defRPr sz="618"/>
            </a:lvl6pPr>
            <a:lvl7pPr marL="1884243" indent="0">
              <a:buNone/>
              <a:defRPr sz="618"/>
            </a:lvl7pPr>
            <a:lvl8pPr marL="2198283" indent="0">
              <a:buNone/>
              <a:defRPr sz="618"/>
            </a:lvl8pPr>
            <a:lvl9pPr marL="2512323" indent="0">
              <a:buNone/>
              <a:defRPr sz="61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8143" y="428041"/>
            <a:ext cx="6806565" cy="1781440"/>
          </a:xfrm>
          <a:prstGeom prst="rect">
            <a:avLst/>
          </a:prstGeom>
        </p:spPr>
        <p:txBody>
          <a:bodyPr vert="horz" lIns="91424" tIns="45712" rIns="91424" bIns="45712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143" y="2494017"/>
            <a:ext cx="6806565" cy="7054007"/>
          </a:xfrm>
          <a:prstGeom prst="rect">
            <a:avLst/>
          </a:prstGeom>
        </p:spPr>
        <p:txBody>
          <a:bodyPr vert="horz" lIns="91424" tIns="45712" rIns="91424" bIns="45712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8143" y="9906789"/>
            <a:ext cx="1764665" cy="569071"/>
          </a:xfrm>
          <a:prstGeom prst="rect">
            <a:avLst/>
          </a:prstGeom>
        </p:spPr>
        <p:txBody>
          <a:bodyPr vert="horz" lIns="91424" tIns="45712" rIns="91424" bIns="45712" rtlCol="0" anchor="ctr"/>
          <a:lstStyle>
            <a:lvl1pPr algn="l">
              <a:defRPr sz="8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9EF8D7-E804-4EB3-87E9-4ABBB065670E}" type="datetimeFigureOut">
              <a:rPr lang="en-US" smtClean="0"/>
              <a:pPr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3975" y="9906789"/>
            <a:ext cx="2394902" cy="569071"/>
          </a:xfrm>
          <a:prstGeom prst="rect">
            <a:avLst/>
          </a:prstGeom>
        </p:spPr>
        <p:txBody>
          <a:bodyPr vert="horz" lIns="91424" tIns="45712" rIns="91424" bIns="45712" rtlCol="0" anchor="ctr"/>
          <a:lstStyle>
            <a:lvl1pPr algn="ctr">
              <a:defRPr sz="8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20043" y="9906789"/>
            <a:ext cx="1764665" cy="569071"/>
          </a:xfrm>
          <a:prstGeom prst="rect">
            <a:avLst/>
          </a:prstGeom>
        </p:spPr>
        <p:txBody>
          <a:bodyPr vert="horz" lIns="91424" tIns="45712" rIns="91424" bIns="45712" rtlCol="0" anchor="ctr"/>
          <a:lstStyle>
            <a:lvl1pPr algn="r">
              <a:defRPr sz="8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938F4F-BC86-43D5-B202-72C568D0BAB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28081" rtl="0" eaLnBrk="1" latinLnBrk="0" hangingPunct="1">
        <a:spcBef>
          <a:spcPct val="0"/>
        </a:spcBef>
        <a:buNone/>
        <a:defRPr sz="30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5531" indent="-235531" algn="l" defTabSz="628081" rtl="0" eaLnBrk="1" latinLnBrk="0" hangingPunct="1">
        <a:spcBef>
          <a:spcPct val="20000"/>
        </a:spcBef>
        <a:buFont typeface="Arial" pitchFamily="34" charset="0"/>
        <a:buChar char="•"/>
        <a:defRPr sz="2198" kern="1200">
          <a:solidFill>
            <a:schemeClr val="tx1"/>
          </a:solidFill>
          <a:latin typeface="+mn-lt"/>
          <a:ea typeface="+mn-ea"/>
          <a:cs typeface="+mn-cs"/>
        </a:defRPr>
      </a:lvl1pPr>
      <a:lvl2pPr marL="510315" indent="-196275" algn="l" defTabSz="628081" rtl="0" eaLnBrk="1" latinLnBrk="0" hangingPunct="1">
        <a:spcBef>
          <a:spcPct val="20000"/>
        </a:spcBef>
        <a:buFont typeface="Arial" pitchFamily="34" charset="0"/>
        <a:buChar char="–"/>
        <a:defRPr sz="1924" kern="1200">
          <a:solidFill>
            <a:schemeClr val="tx1"/>
          </a:solidFill>
          <a:latin typeface="+mn-lt"/>
          <a:ea typeface="+mn-ea"/>
          <a:cs typeface="+mn-cs"/>
        </a:defRPr>
      </a:lvl2pPr>
      <a:lvl3pPr marL="785101" indent="-157021" algn="l" defTabSz="628081" rtl="0" eaLnBrk="1" latinLnBrk="0" hangingPunct="1">
        <a:spcBef>
          <a:spcPct val="20000"/>
        </a:spcBef>
        <a:buFont typeface="Arial" pitchFamily="34" charset="0"/>
        <a:buChar char="•"/>
        <a:defRPr sz="1649" kern="1200">
          <a:solidFill>
            <a:schemeClr val="tx1"/>
          </a:solidFill>
          <a:latin typeface="+mn-lt"/>
          <a:ea typeface="+mn-ea"/>
          <a:cs typeface="+mn-cs"/>
        </a:defRPr>
      </a:lvl3pPr>
      <a:lvl4pPr marL="1099141" indent="-157021" algn="l" defTabSz="628081" rtl="0" eaLnBrk="1" latinLnBrk="0" hangingPunct="1">
        <a:spcBef>
          <a:spcPct val="20000"/>
        </a:spcBef>
        <a:buFont typeface="Arial" pitchFamily="34" charset="0"/>
        <a:buChar char="–"/>
        <a:defRPr sz="1374" kern="1200">
          <a:solidFill>
            <a:schemeClr val="tx1"/>
          </a:solidFill>
          <a:latin typeface="+mn-lt"/>
          <a:ea typeface="+mn-ea"/>
          <a:cs typeface="+mn-cs"/>
        </a:defRPr>
      </a:lvl4pPr>
      <a:lvl5pPr marL="1413182" indent="-157021" algn="l" defTabSz="628081" rtl="0" eaLnBrk="1" latinLnBrk="0" hangingPunct="1">
        <a:spcBef>
          <a:spcPct val="20000"/>
        </a:spcBef>
        <a:buFont typeface="Arial" pitchFamily="34" charset="0"/>
        <a:buChar char="»"/>
        <a:defRPr sz="1374" kern="1200">
          <a:solidFill>
            <a:schemeClr val="tx1"/>
          </a:solidFill>
          <a:latin typeface="+mn-lt"/>
          <a:ea typeface="+mn-ea"/>
          <a:cs typeface="+mn-cs"/>
        </a:defRPr>
      </a:lvl5pPr>
      <a:lvl6pPr marL="1727222" indent="-157021" algn="l" defTabSz="628081" rtl="0" eaLnBrk="1" latinLnBrk="0" hangingPunct="1">
        <a:spcBef>
          <a:spcPct val="20000"/>
        </a:spcBef>
        <a:buFont typeface="Arial" pitchFamily="34" charset="0"/>
        <a:buChar char="•"/>
        <a:defRPr sz="1374" kern="1200">
          <a:solidFill>
            <a:schemeClr val="tx1"/>
          </a:solidFill>
          <a:latin typeface="+mn-lt"/>
          <a:ea typeface="+mn-ea"/>
          <a:cs typeface="+mn-cs"/>
        </a:defRPr>
      </a:lvl6pPr>
      <a:lvl7pPr marL="2041263" indent="-157021" algn="l" defTabSz="628081" rtl="0" eaLnBrk="1" latinLnBrk="0" hangingPunct="1">
        <a:spcBef>
          <a:spcPct val="20000"/>
        </a:spcBef>
        <a:buFont typeface="Arial" pitchFamily="34" charset="0"/>
        <a:buChar char="•"/>
        <a:defRPr sz="1374" kern="1200">
          <a:solidFill>
            <a:schemeClr val="tx1"/>
          </a:solidFill>
          <a:latin typeface="+mn-lt"/>
          <a:ea typeface="+mn-ea"/>
          <a:cs typeface="+mn-cs"/>
        </a:defRPr>
      </a:lvl7pPr>
      <a:lvl8pPr marL="2355303" indent="-157021" algn="l" defTabSz="628081" rtl="0" eaLnBrk="1" latinLnBrk="0" hangingPunct="1">
        <a:spcBef>
          <a:spcPct val="20000"/>
        </a:spcBef>
        <a:buFont typeface="Arial" pitchFamily="34" charset="0"/>
        <a:buChar char="•"/>
        <a:defRPr sz="1374" kern="1200">
          <a:solidFill>
            <a:schemeClr val="tx1"/>
          </a:solidFill>
          <a:latin typeface="+mn-lt"/>
          <a:ea typeface="+mn-ea"/>
          <a:cs typeface="+mn-cs"/>
        </a:defRPr>
      </a:lvl8pPr>
      <a:lvl9pPr marL="2669343" indent="-157021" algn="l" defTabSz="628081" rtl="0" eaLnBrk="1" latinLnBrk="0" hangingPunct="1">
        <a:spcBef>
          <a:spcPct val="20000"/>
        </a:spcBef>
        <a:buFont typeface="Arial" pitchFamily="34" charset="0"/>
        <a:buChar char="•"/>
        <a:defRPr sz="137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8081" rtl="0" eaLnBrk="1" latinLnBrk="0" hangingPunct="1">
        <a:defRPr sz="1237" kern="1200">
          <a:solidFill>
            <a:schemeClr val="tx1"/>
          </a:solidFill>
          <a:latin typeface="+mn-lt"/>
          <a:ea typeface="+mn-ea"/>
          <a:cs typeface="+mn-cs"/>
        </a:defRPr>
      </a:lvl1pPr>
      <a:lvl2pPr marL="314040" algn="l" defTabSz="628081" rtl="0" eaLnBrk="1" latinLnBrk="0" hangingPunct="1">
        <a:defRPr sz="1237" kern="1200">
          <a:solidFill>
            <a:schemeClr val="tx1"/>
          </a:solidFill>
          <a:latin typeface="+mn-lt"/>
          <a:ea typeface="+mn-ea"/>
          <a:cs typeface="+mn-cs"/>
        </a:defRPr>
      </a:lvl2pPr>
      <a:lvl3pPr marL="628081" algn="l" defTabSz="628081" rtl="0" eaLnBrk="1" latinLnBrk="0" hangingPunct="1">
        <a:defRPr sz="1237" kern="1200">
          <a:solidFill>
            <a:schemeClr val="tx1"/>
          </a:solidFill>
          <a:latin typeface="+mn-lt"/>
          <a:ea typeface="+mn-ea"/>
          <a:cs typeface="+mn-cs"/>
        </a:defRPr>
      </a:lvl3pPr>
      <a:lvl4pPr marL="942120" algn="l" defTabSz="628081" rtl="0" eaLnBrk="1" latinLnBrk="0" hangingPunct="1">
        <a:defRPr sz="1237" kern="1200">
          <a:solidFill>
            <a:schemeClr val="tx1"/>
          </a:solidFill>
          <a:latin typeface="+mn-lt"/>
          <a:ea typeface="+mn-ea"/>
          <a:cs typeface="+mn-cs"/>
        </a:defRPr>
      </a:lvl4pPr>
      <a:lvl5pPr marL="1256162" algn="l" defTabSz="628081" rtl="0" eaLnBrk="1" latinLnBrk="0" hangingPunct="1">
        <a:defRPr sz="1237" kern="1200">
          <a:solidFill>
            <a:schemeClr val="tx1"/>
          </a:solidFill>
          <a:latin typeface="+mn-lt"/>
          <a:ea typeface="+mn-ea"/>
          <a:cs typeface="+mn-cs"/>
        </a:defRPr>
      </a:lvl5pPr>
      <a:lvl6pPr marL="1570202" algn="l" defTabSz="628081" rtl="0" eaLnBrk="1" latinLnBrk="0" hangingPunct="1">
        <a:defRPr sz="1237" kern="1200">
          <a:solidFill>
            <a:schemeClr val="tx1"/>
          </a:solidFill>
          <a:latin typeface="+mn-lt"/>
          <a:ea typeface="+mn-ea"/>
          <a:cs typeface="+mn-cs"/>
        </a:defRPr>
      </a:lvl6pPr>
      <a:lvl7pPr marL="1884243" algn="l" defTabSz="628081" rtl="0" eaLnBrk="1" latinLnBrk="0" hangingPunct="1">
        <a:defRPr sz="1237" kern="1200">
          <a:solidFill>
            <a:schemeClr val="tx1"/>
          </a:solidFill>
          <a:latin typeface="+mn-lt"/>
          <a:ea typeface="+mn-ea"/>
          <a:cs typeface="+mn-cs"/>
        </a:defRPr>
      </a:lvl7pPr>
      <a:lvl8pPr marL="2198283" algn="l" defTabSz="628081" rtl="0" eaLnBrk="1" latinLnBrk="0" hangingPunct="1">
        <a:defRPr sz="1237" kern="1200">
          <a:solidFill>
            <a:schemeClr val="tx1"/>
          </a:solidFill>
          <a:latin typeface="+mn-lt"/>
          <a:ea typeface="+mn-ea"/>
          <a:cs typeface="+mn-cs"/>
        </a:defRPr>
      </a:lvl8pPr>
      <a:lvl9pPr marL="2512323" algn="l" defTabSz="628081" rtl="0" eaLnBrk="1" latinLnBrk="0" hangingPunct="1">
        <a:defRPr sz="123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8143" y="428041"/>
            <a:ext cx="6806565" cy="1781440"/>
          </a:xfrm>
          <a:prstGeom prst="rect">
            <a:avLst/>
          </a:prstGeom>
        </p:spPr>
        <p:txBody>
          <a:bodyPr vert="horz" lIns="96661" tIns="48331" rIns="96661" bIns="48331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143" y="2494016"/>
            <a:ext cx="6806565" cy="7054007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8143" y="9906785"/>
            <a:ext cx="1764665" cy="569071"/>
          </a:xfrm>
          <a:prstGeom prst="rect">
            <a:avLst/>
          </a:prstGeom>
        </p:spPr>
        <p:txBody>
          <a:bodyPr vert="horz" lIns="96661" tIns="48331" rIns="96661" bIns="48331" rtlCol="0" anchor="ctr"/>
          <a:lstStyle>
            <a:lvl1pPr algn="l">
              <a:defRPr sz="10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F2374E-85C7-41A2-B36A-16B8991CADED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3974" y="9906785"/>
            <a:ext cx="2394903" cy="569071"/>
          </a:xfrm>
          <a:prstGeom prst="rect">
            <a:avLst/>
          </a:prstGeom>
        </p:spPr>
        <p:txBody>
          <a:bodyPr vert="horz" lIns="96661" tIns="48331" rIns="96661" bIns="48331" rtlCol="0" anchor="ctr"/>
          <a:lstStyle>
            <a:lvl1pPr algn="ctr">
              <a:defRPr sz="10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20043" y="9906785"/>
            <a:ext cx="1764665" cy="569071"/>
          </a:xfrm>
          <a:prstGeom prst="rect">
            <a:avLst/>
          </a:prstGeom>
        </p:spPr>
        <p:txBody>
          <a:bodyPr vert="horz" lIns="96661" tIns="48331" rIns="96661" bIns="48331" rtlCol="0" anchor="ctr"/>
          <a:lstStyle>
            <a:lvl1pPr algn="r">
              <a:defRPr sz="10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0CB6F-855B-494B-AFD4-175B7D3AC5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030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761400" rtl="0" eaLnBrk="1" latinLnBrk="0" hangingPunct="1">
        <a:spcBef>
          <a:spcPct val="0"/>
        </a:spcBef>
        <a:buNone/>
        <a:defRPr sz="370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5525" indent="-285525" algn="l" defTabSz="761400" rtl="0" eaLnBrk="1" latinLnBrk="0" hangingPunct="1">
        <a:spcBef>
          <a:spcPct val="20000"/>
        </a:spcBef>
        <a:buFont typeface="Arial" pitchFamily="34" charset="0"/>
        <a:buChar char="•"/>
        <a:defRPr sz="2678" kern="1200">
          <a:solidFill>
            <a:schemeClr val="tx1"/>
          </a:solidFill>
          <a:latin typeface="+mn-lt"/>
          <a:ea typeface="+mn-ea"/>
          <a:cs typeface="+mn-cs"/>
        </a:defRPr>
      </a:lvl1pPr>
      <a:lvl2pPr marL="618638" indent="-237937" algn="l" defTabSz="761400" rtl="0" eaLnBrk="1" latinLnBrk="0" hangingPunct="1">
        <a:spcBef>
          <a:spcPct val="20000"/>
        </a:spcBef>
        <a:buFont typeface="Arial" pitchFamily="34" charset="0"/>
        <a:buChar char="–"/>
        <a:defRPr sz="2363" kern="1200">
          <a:solidFill>
            <a:schemeClr val="tx1"/>
          </a:solidFill>
          <a:latin typeface="+mn-lt"/>
          <a:ea typeface="+mn-ea"/>
          <a:cs typeface="+mn-cs"/>
        </a:defRPr>
      </a:lvl2pPr>
      <a:lvl3pPr marL="951750" indent="-190350" algn="l" defTabSz="761400" rtl="0" eaLnBrk="1" latinLnBrk="0" hangingPunct="1">
        <a:spcBef>
          <a:spcPct val="20000"/>
        </a:spcBef>
        <a:buFont typeface="Arial" pitchFamily="34" charset="0"/>
        <a:buChar char="•"/>
        <a:defRPr sz="1969" kern="1200">
          <a:solidFill>
            <a:schemeClr val="tx1"/>
          </a:solidFill>
          <a:latin typeface="+mn-lt"/>
          <a:ea typeface="+mn-ea"/>
          <a:cs typeface="+mn-cs"/>
        </a:defRPr>
      </a:lvl3pPr>
      <a:lvl4pPr marL="1332450" indent="-190350" algn="l" defTabSz="761400" rtl="0" eaLnBrk="1" latinLnBrk="0" hangingPunct="1">
        <a:spcBef>
          <a:spcPct val="20000"/>
        </a:spcBef>
        <a:buFont typeface="Arial" pitchFamily="34" charset="0"/>
        <a:buChar char="–"/>
        <a:defRPr sz="1654" kern="1200">
          <a:solidFill>
            <a:schemeClr val="tx1"/>
          </a:solidFill>
          <a:latin typeface="+mn-lt"/>
          <a:ea typeface="+mn-ea"/>
          <a:cs typeface="+mn-cs"/>
        </a:defRPr>
      </a:lvl4pPr>
      <a:lvl5pPr marL="1713151" indent="-190350" algn="l" defTabSz="761400" rtl="0" eaLnBrk="1" latinLnBrk="0" hangingPunct="1">
        <a:spcBef>
          <a:spcPct val="20000"/>
        </a:spcBef>
        <a:buFont typeface="Arial" pitchFamily="34" charset="0"/>
        <a:buChar char="»"/>
        <a:defRPr sz="1654" kern="1200">
          <a:solidFill>
            <a:schemeClr val="tx1"/>
          </a:solidFill>
          <a:latin typeface="+mn-lt"/>
          <a:ea typeface="+mn-ea"/>
          <a:cs typeface="+mn-cs"/>
        </a:defRPr>
      </a:lvl5pPr>
      <a:lvl6pPr marL="2093852" indent="-190350" algn="l" defTabSz="761400" rtl="0" eaLnBrk="1" latinLnBrk="0" hangingPunct="1">
        <a:spcBef>
          <a:spcPct val="20000"/>
        </a:spcBef>
        <a:buFont typeface="Arial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6pPr>
      <a:lvl7pPr marL="2474552" indent="-190350" algn="l" defTabSz="761400" rtl="0" eaLnBrk="1" latinLnBrk="0" hangingPunct="1">
        <a:spcBef>
          <a:spcPct val="20000"/>
        </a:spcBef>
        <a:buFont typeface="Arial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7pPr>
      <a:lvl8pPr marL="2855252" indent="-190350" algn="l" defTabSz="761400" rtl="0" eaLnBrk="1" latinLnBrk="0" hangingPunct="1">
        <a:spcBef>
          <a:spcPct val="20000"/>
        </a:spcBef>
        <a:buFont typeface="Arial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8pPr>
      <a:lvl9pPr marL="3235952" indent="-190350" algn="l" defTabSz="761400" rtl="0" eaLnBrk="1" latinLnBrk="0" hangingPunct="1">
        <a:spcBef>
          <a:spcPct val="20000"/>
        </a:spcBef>
        <a:buFont typeface="Arial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61400" rtl="0" eaLnBrk="1" latinLnBrk="0" hangingPunct="1">
        <a:defRPr sz="1497" kern="1200">
          <a:solidFill>
            <a:schemeClr val="tx1"/>
          </a:solidFill>
          <a:latin typeface="+mn-lt"/>
          <a:ea typeface="+mn-ea"/>
          <a:cs typeface="+mn-cs"/>
        </a:defRPr>
      </a:lvl1pPr>
      <a:lvl2pPr marL="380700" algn="l" defTabSz="761400" rtl="0" eaLnBrk="1" latinLnBrk="0" hangingPunct="1">
        <a:defRPr sz="1497" kern="1200">
          <a:solidFill>
            <a:schemeClr val="tx1"/>
          </a:solidFill>
          <a:latin typeface="+mn-lt"/>
          <a:ea typeface="+mn-ea"/>
          <a:cs typeface="+mn-cs"/>
        </a:defRPr>
      </a:lvl2pPr>
      <a:lvl3pPr marL="761400" algn="l" defTabSz="761400" rtl="0" eaLnBrk="1" latinLnBrk="0" hangingPunct="1">
        <a:defRPr sz="1497" kern="1200">
          <a:solidFill>
            <a:schemeClr val="tx1"/>
          </a:solidFill>
          <a:latin typeface="+mn-lt"/>
          <a:ea typeface="+mn-ea"/>
          <a:cs typeface="+mn-cs"/>
        </a:defRPr>
      </a:lvl3pPr>
      <a:lvl4pPr marL="1142100" algn="l" defTabSz="761400" rtl="0" eaLnBrk="1" latinLnBrk="0" hangingPunct="1">
        <a:defRPr sz="1497" kern="1200">
          <a:solidFill>
            <a:schemeClr val="tx1"/>
          </a:solidFill>
          <a:latin typeface="+mn-lt"/>
          <a:ea typeface="+mn-ea"/>
          <a:cs typeface="+mn-cs"/>
        </a:defRPr>
      </a:lvl4pPr>
      <a:lvl5pPr marL="1522801" algn="l" defTabSz="761400" rtl="0" eaLnBrk="1" latinLnBrk="0" hangingPunct="1">
        <a:defRPr sz="1497" kern="1200">
          <a:solidFill>
            <a:schemeClr val="tx1"/>
          </a:solidFill>
          <a:latin typeface="+mn-lt"/>
          <a:ea typeface="+mn-ea"/>
          <a:cs typeface="+mn-cs"/>
        </a:defRPr>
      </a:lvl5pPr>
      <a:lvl6pPr marL="1903501" algn="l" defTabSz="761400" rtl="0" eaLnBrk="1" latinLnBrk="0" hangingPunct="1">
        <a:defRPr sz="1497" kern="1200">
          <a:solidFill>
            <a:schemeClr val="tx1"/>
          </a:solidFill>
          <a:latin typeface="+mn-lt"/>
          <a:ea typeface="+mn-ea"/>
          <a:cs typeface="+mn-cs"/>
        </a:defRPr>
      </a:lvl6pPr>
      <a:lvl7pPr marL="2284202" algn="l" defTabSz="761400" rtl="0" eaLnBrk="1" latinLnBrk="0" hangingPunct="1">
        <a:defRPr sz="1497" kern="1200">
          <a:solidFill>
            <a:schemeClr val="tx1"/>
          </a:solidFill>
          <a:latin typeface="+mn-lt"/>
          <a:ea typeface="+mn-ea"/>
          <a:cs typeface="+mn-cs"/>
        </a:defRPr>
      </a:lvl7pPr>
      <a:lvl8pPr marL="2664902" algn="l" defTabSz="761400" rtl="0" eaLnBrk="1" latinLnBrk="0" hangingPunct="1">
        <a:defRPr sz="1497" kern="1200">
          <a:solidFill>
            <a:schemeClr val="tx1"/>
          </a:solidFill>
          <a:latin typeface="+mn-lt"/>
          <a:ea typeface="+mn-ea"/>
          <a:cs typeface="+mn-cs"/>
        </a:defRPr>
      </a:lvl8pPr>
      <a:lvl9pPr marL="3045602" algn="l" defTabSz="761400" rtl="0" eaLnBrk="1" latinLnBrk="0" hangingPunct="1">
        <a:defRPr sz="149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13.xml"/><Relationship Id="rId4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2">
            <a:extLst>
              <a:ext uri="{FF2B5EF4-FFF2-40B4-BE49-F238E27FC236}">
                <a16:creationId xmlns:a16="http://schemas.microsoft.com/office/drawing/2014/main" id="{095AEB01-EA95-9000-B0CC-239F2A8B64FC}"/>
              </a:ext>
            </a:extLst>
          </p:cNvPr>
          <p:cNvGrpSpPr/>
          <p:nvPr/>
        </p:nvGrpSpPr>
        <p:grpSpPr>
          <a:xfrm>
            <a:off x="123825" y="391353"/>
            <a:ext cx="7315200" cy="8001000"/>
            <a:chOff x="123825" y="1458119"/>
            <a:chExt cx="7315200" cy="8001000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EDE335E5-013F-DDAE-8C8C-76C0F6298EF2}"/>
                </a:ext>
              </a:extLst>
            </p:cNvPr>
            <p:cNvSpPr/>
            <p:nvPr/>
          </p:nvSpPr>
          <p:spPr>
            <a:xfrm>
              <a:off x="123825" y="1458119"/>
              <a:ext cx="7315200" cy="8001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5D5A2DB0-0901-9952-CF07-CC99417DBF67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544280872"/>
                </p:ext>
              </p:extLst>
            </p:nvPr>
          </p:nvGraphicFramePr>
          <p:xfrm>
            <a:off x="542710" y="1854706"/>
            <a:ext cx="3108960" cy="21945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79964493-5F52-1DD4-49B3-B89B7F36EB61}"/>
                </a:ext>
              </a:extLst>
            </p:cNvPr>
            <p:cNvSpPr/>
            <p:nvPr/>
          </p:nvSpPr>
          <p:spPr>
            <a:xfrm>
              <a:off x="149987" y="1460266"/>
              <a:ext cx="366561" cy="356576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86908E48-B8BD-C8A3-4691-D295F5FE204B}"/>
                </a:ext>
              </a:extLst>
            </p:cNvPr>
            <p:cNvSpPr/>
            <p:nvPr/>
          </p:nvSpPr>
          <p:spPr>
            <a:xfrm>
              <a:off x="3978164" y="1458119"/>
              <a:ext cx="366561" cy="356576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E5B932A-AC77-2F6F-B3BF-0ACB41AF0AEC}"/>
                </a:ext>
              </a:extLst>
            </p:cNvPr>
            <p:cNvSpPr/>
            <p:nvPr/>
          </p:nvSpPr>
          <p:spPr>
            <a:xfrm>
              <a:off x="149987" y="4016110"/>
              <a:ext cx="366561" cy="356576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F53048BC-9FE3-2457-3A02-7FFB2B1DF592}"/>
                </a:ext>
              </a:extLst>
            </p:cNvPr>
            <p:cNvSpPr/>
            <p:nvPr/>
          </p:nvSpPr>
          <p:spPr>
            <a:xfrm>
              <a:off x="4007070" y="4035138"/>
              <a:ext cx="366561" cy="356576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1274B80-002E-45C4-C345-0741CA42C7EF}"/>
                </a:ext>
              </a:extLst>
            </p:cNvPr>
            <p:cNvSpPr/>
            <p:nvPr/>
          </p:nvSpPr>
          <p:spPr>
            <a:xfrm>
              <a:off x="158048" y="6497367"/>
              <a:ext cx="366561" cy="356576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5C10DEB4-EB03-925E-BB1B-3FEEFDBB759B}"/>
                </a:ext>
              </a:extLst>
            </p:cNvPr>
            <p:cNvSpPr/>
            <p:nvPr/>
          </p:nvSpPr>
          <p:spPr>
            <a:xfrm>
              <a:off x="3949500" y="6509949"/>
              <a:ext cx="366561" cy="356576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8BC72B3-CB8D-32A0-639B-00E31596346F}"/>
                </a:ext>
              </a:extLst>
            </p:cNvPr>
            <p:cNvSpPr txBox="1"/>
            <p:nvPr/>
          </p:nvSpPr>
          <p:spPr>
            <a:xfrm>
              <a:off x="242031" y="1839119"/>
              <a:ext cx="451406" cy="2039737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cellular CO</a:t>
              </a:r>
              <a:r>
                <a:rPr lang="en-US" sz="11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US" sz="1100" b="1" i="0" baseline="0" dirty="0">
                  <a:latin typeface="Times New Roman" panose="02020603050405020304" pitchFamily="18" charset="0"/>
                  <a:cs typeface="Times New Roman" pitchFamily="18" charset="0"/>
                </a:rPr>
                <a:t>µmol mol</a:t>
              </a:r>
              <a:r>
                <a:rPr lang="en-US" sz="1100" b="1" i="0" baseline="30000" dirty="0">
                  <a:latin typeface="Times New Roman" panose="02020603050405020304" pitchFamily="18" charset="0"/>
                  <a:cs typeface="Times New Roman" pitchFamily="18" charset="0"/>
                </a:rPr>
                <a:t>-1</a:t>
              </a:r>
              <a:r>
                <a:rPr lang="en-US" sz="1100" b="1" i="0" dirty="0">
                  <a:latin typeface="Times New Roman" panose="02020603050405020304" pitchFamily="18" charset="0"/>
                  <a:cs typeface="Times New Roman" pitchFamily="18" charset="0"/>
                </a:rPr>
                <a:t>)</a:t>
              </a:r>
              <a:endParaRPr lang="en-US" sz="1100" b="1" i="0" baseline="0" dirty="0">
                <a:latin typeface="Times New Roman" panose="02020603050405020304" pitchFamily="18" charset="0"/>
                <a:cs typeface="Times New Roman" pitchFamily="18" charset="0"/>
              </a:endParaRPr>
            </a:p>
            <a:p>
              <a:pPr algn="ctr" rtl="0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endPara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EB94853-47CD-DF2C-0EDF-CDD3229A8D14}"/>
                </a:ext>
              </a:extLst>
            </p:cNvPr>
            <p:cNvSpPr txBox="1"/>
            <p:nvPr/>
          </p:nvSpPr>
          <p:spPr>
            <a:xfrm>
              <a:off x="4016852" y="1839119"/>
              <a:ext cx="451406" cy="2039737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cellular CO</a:t>
              </a:r>
              <a:r>
                <a:rPr lang="en-US" sz="11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US" sz="1100" b="1" i="0" baseline="0" dirty="0">
                  <a:latin typeface="Times New Roman" panose="02020603050405020304" pitchFamily="18" charset="0"/>
                  <a:cs typeface="Times New Roman" pitchFamily="18" charset="0"/>
                </a:rPr>
                <a:t>µmol mol</a:t>
              </a:r>
              <a:r>
                <a:rPr lang="en-US" sz="1100" b="1" i="0" baseline="30000" dirty="0">
                  <a:latin typeface="Times New Roman" panose="02020603050405020304" pitchFamily="18" charset="0"/>
                  <a:cs typeface="Times New Roman" pitchFamily="18" charset="0"/>
                </a:rPr>
                <a:t>-1</a:t>
              </a:r>
              <a:r>
                <a:rPr lang="en-US" sz="1100" b="1" i="0" dirty="0">
                  <a:latin typeface="Times New Roman" panose="02020603050405020304" pitchFamily="18" charset="0"/>
                  <a:cs typeface="Times New Roman" pitchFamily="18" charset="0"/>
                </a:rPr>
                <a:t>)</a:t>
              </a:r>
              <a:endParaRPr lang="en-US" sz="1100" b="1" i="0" baseline="0" dirty="0">
                <a:latin typeface="Times New Roman" panose="02020603050405020304" pitchFamily="18" charset="0"/>
                <a:cs typeface="Times New Roman" pitchFamily="18" charset="0"/>
              </a:endParaRPr>
            </a:p>
            <a:p>
              <a:pPr algn="ctr" rtl="0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endPara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20">
              <a:extLst>
                <a:ext uri="{FF2B5EF4-FFF2-40B4-BE49-F238E27FC236}">
                  <a16:creationId xmlns:a16="http://schemas.microsoft.com/office/drawing/2014/main" id="{9CACD9DE-6DE9-963C-0D0A-6A129B5C109A}"/>
                </a:ext>
              </a:extLst>
            </p:cNvPr>
            <p:cNvSpPr txBox="1"/>
            <p:nvPr/>
          </p:nvSpPr>
          <p:spPr>
            <a:xfrm>
              <a:off x="1019175" y="2220119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20" name="TextBox 20">
              <a:extLst>
                <a:ext uri="{FF2B5EF4-FFF2-40B4-BE49-F238E27FC236}">
                  <a16:creationId xmlns:a16="http://schemas.microsoft.com/office/drawing/2014/main" id="{CCE3C174-3C9B-A317-89E7-6F7C55C51684}"/>
                </a:ext>
              </a:extLst>
            </p:cNvPr>
            <p:cNvSpPr txBox="1"/>
            <p:nvPr/>
          </p:nvSpPr>
          <p:spPr>
            <a:xfrm>
              <a:off x="1553647" y="2035453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DC749FD-759E-C572-8A83-2B7555CBC735}"/>
                </a:ext>
              </a:extLst>
            </p:cNvPr>
            <p:cNvSpPr txBox="1"/>
            <p:nvPr/>
          </p:nvSpPr>
          <p:spPr>
            <a:xfrm>
              <a:off x="2053825" y="2151622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2" name="TextBox 20">
              <a:extLst>
                <a:ext uri="{FF2B5EF4-FFF2-40B4-BE49-F238E27FC236}">
                  <a16:creationId xmlns:a16="http://schemas.microsoft.com/office/drawing/2014/main" id="{27FD15AE-959E-7B37-8234-987BB0599506}"/>
                </a:ext>
              </a:extLst>
            </p:cNvPr>
            <p:cNvSpPr txBox="1"/>
            <p:nvPr/>
          </p:nvSpPr>
          <p:spPr>
            <a:xfrm>
              <a:off x="2562608" y="2081284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23" name="TextBox 20">
              <a:extLst>
                <a:ext uri="{FF2B5EF4-FFF2-40B4-BE49-F238E27FC236}">
                  <a16:creationId xmlns:a16="http://schemas.microsoft.com/office/drawing/2014/main" id="{2A9F09B8-4CAB-1E53-53D6-9A59532D66F4}"/>
                </a:ext>
              </a:extLst>
            </p:cNvPr>
            <p:cNvSpPr txBox="1"/>
            <p:nvPr/>
          </p:nvSpPr>
          <p:spPr>
            <a:xfrm>
              <a:off x="3083705" y="2220119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graphicFrame>
          <p:nvGraphicFramePr>
            <p:cNvPr id="25" name="Chart 4">
              <a:extLst>
                <a:ext uri="{FF2B5EF4-FFF2-40B4-BE49-F238E27FC236}">
                  <a16:creationId xmlns:a16="http://schemas.microsoft.com/office/drawing/2014/main" id="{13FEF970-8B91-51D6-51B3-DA0758679E36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913690025"/>
                </p:ext>
              </p:extLst>
            </p:nvPr>
          </p:nvGraphicFramePr>
          <p:xfrm>
            <a:off x="4285159" y="1854706"/>
            <a:ext cx="3108960" cy="21945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6" name="TextBox 20">
              <a:extLst>
                <a:ext uri="{FF2B5EF4-FFF2-40B4-BE49-F238E27FC236}">
                  <a16:creationId xmlns:a16="http://schemas.microsoft.com/office/drawing/2014/main" id="{F0E44E03-4FC1-0F56-CD64-6C7F7B9B205D}"/>
                </a:ext>
              </a:extLst>
            </p:cNvPr>
            <p:cNvSpPr txBox="1"/>
            <p:nvPr/>
          </p:nvSpPr>
          <p:spPr>
            <a:xfrm>
              <a:off x="4785958" y="1977850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b</a:t>
              </a:r>
            </a:p>
          </p:txBody>
        </p:sp>
        <p:sp>
          <p:nvSpPr>
            <p:cNvPr id="27" name="TextBox 20">
              <a:extLst>
                <a:ext uri="{FF2B5EF4-FFF2-40B4-BE49-F238E27FC236}">
                  <a16:creationId xmlns:a16="http://schemas.microsoft.com/office/drawing/2014/main" id="{BFE9ABBF-91E8-0D4A-B1BE-E4109E7ED2DC}"/>
                </a:ext>
              </a:extLst>
            </p:cNvPr>
            <p:cNvSpPr txBox="1"/>
            <p:nvPr/>
          </p:nvSpPr>
          <p:spPr>
            <a:xfrm>
              <a:off x="5779434" y="2151622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28" name="TextBox 20">
              <a:extLst>
                <a:ext uri="{FF2B5EF4-FFF2-40B4-BE49-F238E27FC236}">
                  <a16:creationId xmlns:a16="http://schemas.microsoft.com/office/drawing/2014/main" id="{F19B9E1A-E9CA-E790-CF5E-FF2E53CE1D11}"/>
                </a:ext>
              </a:extLst>
            </p:cNvPr>
            <p:cNvSpPr txBox="1"/>
            <p:nvPr/>
          </p:nvSpPr>
          <p:spPr>
            <a:xfrm>
              <a:off x="6286957" y="2070183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A6CE58C-2496-FC14-E47F-3ED76825C619}"/>
                </a:ext>
              </a:extLst>
            </p:cNvPr>
            <p:cNvSpPr txBox="1"/>
            <p:nvPr/>
          </p:nvSpPr>
          <p:spPr>
            <a:xfrm>
              <a:off x="6787446" y="1925806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031F1D7-43B0-4568-14DB-4C97BB87654D}"/>
                </a:ext>
              </a:extLst>
            </p:cNvPr>
            <p:cNvSpPr txBox="1"/>
            <p:nvPr/>
          </p:nvSpPr>
          <p:spPr>
            <a:xfrm>
              <a:off x="5282696" y="2012453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01F6B38-EAAC-5CE4-3EC7-48CC96BE2298}"/>
                </a:ext>
              </a:extLst>
            </p:cNvPr>
            <p:cNvSpPr txBox="1"/>
            <p:nvPr/>
          </p:nvSpPr>
          <p:spPr>
            <a:xfrm>
              <a:off x="188323" y="4277519"/>
              <a:ext cx="451406" cy="2039737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piration Rate </a:t>
              </a:r>
            </a:p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b="1" i="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mmol m</a:t>
              </a:r>
              <a:r>
                <a:rPr lang="en-US" sz="1100" b="1" i="0" baseline="3000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−2</a:t>
              </a:r>
              <a:r>
                <a:rPr lang="en-US" sz="1100" b="1" i="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 s</a:t>
              </a:r>
              <a:r>
                <a:rPr lang="en-US" sz="1100" b="1" i="0" baseline="3000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−1</a:t>
              </a:r>
              <a:r>
                <a:rPr lang="en-US" sz="1100" b="1" i="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US" sz="1100" b="1" i="0" baseline="0" dirty="0">
                <a:latin typeface="Times New Roman" panose="02020603050405020304" pitchFamily="18" charset="0"/>
                <a:cs typeface="Times New Roman" pitchFamily="18" charset="0"/>
              </a:endParaRPr>
            </a:p>
            <a:p>
              <a:pPr algn="ctr" rtl="0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endPara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587B9B3-234D-B9B4-6580-73B6DAC434D2}"/>
                </a:ext>
              </a:extLst>
            </p:cNvPr>
            <p:cNvSpPr txBox="1"/>
            <p:nvPr/>
          </p:nvSpPr>
          <p:spPr>
            <a:xfrm>
              <a:off x="216832" y="6792119"/>
              <a:ext cx="451406" cy="2039737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omatal Conductance (</a:t>
              </a:r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sz="1100" baseline="-25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(mmolm</a:t>
              </a:r>
              <a:r>
                <a:rPr lang="en-US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2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1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US" sz="1100" b="1" i="0" baseline="30000" dirty="0">
                <a:latin typeface="Times New Roman" panose="02020603050405020304" pitchFamily="18" charset="0"/>
                <a:cs typeface="Times New Roman" pitchFamily="18" charset="0"/>
              </a:endParaRPr>
            </a:p>
            <a:p>
              <a:pPr algn="ctr" rtl="0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endPara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33" name="Chart 32">
              <a:extLst>
                <a:ext uri="{FF2B5EF4-FFF2-40B4-BE49-F238E27FC236}">
                  <a16:creationId xmlns:a16="http://schemas.microsoft.com/office/drawing/2014/main" id="{BA0BD0E1-2BAA-2666-C87F-5D633BA964BF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938063258"/>
                </p:ext>
              </p:extLst>
            </p:nvPr>
          </p:nvGraphicFramePr>
          <p:xfrm>
            <a:off x="417968" y="4355950"/>
            <a:ext cx="3108960" cy="21945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4" name="TextBox 20">
              <a:extLst>
                <a:ext uri="{FF2B5EF4-FFF2-40B4-BE49-F238E27FC236}">
                  <a16:creationId xmlns:a16="http://schemas.microsoft.com/office/drawing/2014/main" id="{6617A065-EDC9-3AE4-82F5-638569FE4238}"/>
                </a:ext>
              </a:extLst>
            </p:cNvPr>
            <p:cNvSpPr txBox="1"/>
            <p:nvPr/>
          </p:nvSpPr>
          <p:spPr>
            <a:xfrm>
              <a:off x="894168" y="4672309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35" name="TextBox 20">
              <a:extLst>
                <a:ext uri="{FF2B5EF4-FFF2-40B4-BE49-F238E27FC236}">
                  <a16:creationId xmlns:a16="http://schemas.microsoft.com/office/drawing/2014/main" id="{68CE9590-82E4-E091-1C5A-6F81425FEF48}"/>
                </a:ext>
              </a:extLst>
            </p:cNvPr>
            <p:cNvSpPr txBox="1"/>
            <p:nvPr/>
          </p:nvSpPr>
          <p:spPr>
            <a:xfrm>
              <a:off x="1420819" y="4672309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b</a:t>
              </a:r>
            </a:p>
          </p:txBody>
        </p:sp>
        <p:sp>
          <p:nvSpPr>
            <p:cNvPr id="36" name="TextBox 20">
              <a:extLst>
                <a:ext uri="{FF2B5EF4-FFF2-40B4-BE49-F238E27FC236}">
                  <a16:creationId xmlns:a16="http://schemas.microsoft.com/office/drawing/2014/main" id="{062E6613-998D-83A9-EDD2-A8AD60A8DC0F}"/>
                </a:ext>
              </a:extLst>
            </p:cNvPr>
            <p:cNvSpPr txBox="1"/>
            <p:nvPr/>
          </p:nvSpPr>
          <p:spPr>
            <a:xfrm>
              <a:off x="1934077" y="4806660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</a:t>
              </a:r>
            </a:p>
          </p:txBody>
        </p:sp>
        <p:sp>
          <p:nvSpPr>
            <p:cNvPr id="37" name="TextBox 20">
              <a:extLst>
                <a:ext uri="{FF2B5EF4-FFF2-40B4-BE49-F238E27FC236}">
                  <a16:creationId xmlns:a16="http://schemas.microsoft.com/office/drawing/2014/main" id="{E6274C0A-CA72-66E5-E75C-00029289A091}"/>
                </a:ext>
              </a:extLst>
            </p:cNvPr>
            <p:cNvSpPr txBox="1"/>
            <p:nvPr/>
          </p:nvSpPr>
          <p:spPr>
            <a:xfrm>
              <a:off x="2458558" y="4571430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38" name="TextBox 20">
              <a:extLst>
                <a:ext uri="{FF2B5EF4-FFF2-40B4-BE49-F238E27FC236}">
                  <a16:creationId xmlns:a16="http://schemas.microsoft.com/office/drawing/2014/main" id="{FF1BA13B-E61E-E4FC-A47F-BF7C7A4066BE}"/>
                </a:ext>
              </a:extLst>
            </p:cNvPr>
            <p:cNvSpPr txBox="1"/>
            <p:nvPr/>
          </p:nvSpPr>
          <p:spPr>
            <a:xfrm>
              <a:off x="2985209" y="4628375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b</a:t>
              </a:r>
            </a:p>
          </p:txBody>
        </p:sp>
        <p:graphicFrame>
          <p:nvGraphicFramePr>
            <p:cNvPr id="39" name="Chart 38">
              <a:extLst>
                <a:ext uri="{FF2B5EF4-FFF2-40B4-BE49-F238E27FC236}">
                  <a16:creationId xmlns:a16="http://schemas.microsoft.com/office/drawing/2014/main" id="{CB33FFF0-5343-40CD-482A-804F87877A4C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970211484"/>
                </p:ext>
              </p:extLst>
            </p:nvPr>
          </p:nvGraphicFramePr>
          <p:xfrm>
            <a:off x="4253356" y="4355950"/>
            <a:ext cx="3108960" cy="21945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8827154-01EF-D044-E4DC-59891D32AA20}"/>
                </a:ext>
              </a:extLst>
            </p:cNvPr>
            <p:cNvSpPr txBox="1"/>
            <p:nvPr/>
          </p:nvSpPr>
          <p:spPr>
            <a:xfrm>
              <a:off x="4007070" y="4277519"/>
              <a:ext cx="451406" cy="2039737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piration Rate </a:t>
              </a:r>
            </a:p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b="1" i="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mmol m</a:t>
              </a:r>
              <a:r>
                <a:rPr lang="en-US" sz="1100" b="1" i="0" baseline="3000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−2</a:t>
              </a:r>
              <a:r>
                <a:rPr lang="en-US" sz="1100" b="1" i="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 s</a:t>
              </a:r>
              <a:r>
                <a:rPr lang="en-US" sz="1100" b="1" i="0" baseline="3000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−1</a:t>
              </a:r>
              <a:r>
                <a:rPr lang="en-US" sz="1100" b="1" i="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US" sz="1100" b="1" i="0" baseline="0" dirty="0">
                <a:latin typeface="Times New Roman" panose="02020603050405020304" pitchFamily="18" charset="0"/>
                <a:cs typeface="Times New Roman" pitchFamily="18" charset="0"/>
              </a:endParaRPr>
            </a:p>
            <a:p>
              <a:pPr algn="ctr" rtl="0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endPara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20">
              <a:extLst>
                <a:ext uri="{FF2B5EF4-FFF2-40B4-BE49-F238E27FC236}">
                  <a16:creationId xmlns:a16="http://schemas.microsoft.com/office/drawing/2014/main" id="{311F765F-48F8-A80E-00C6-7FF12C6426A1}"/>
                </a:ext>
              </a:extLst>
            </p:cNvPr>
            <p:cNvSpPr txBox="1"/>
            <p:nvPr/>
          </p:nvSpPr>
          <p:spPr>
            <a:xfrm>
              <a:off x="4749453" y="4596123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42" name="TextBox 20">
              <a:extLst>
                <a:ext uri="{FF2B5EF4-FFF2-40B4-BE49-F238E27FC236}">
                  <a16:creationId xmlns:a16="http://schemas.microsoft.com/office/drawing/2014/main" id="{6A670F26-EB58-7AC5-DC75-093A8E0455D2}"/>
                </a:ext>
              </a:extLst>
            </p:cNvPr>
            <p:cNvSpPr txBox="1"/>
            <p:nvPr/>
          </p:nvSpPr>
          <p:spPr>
            <a:xfrm>
              <a:off x="5277486" y="4611713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3" name="TextBox 20">
              <a:extLst>
                <a:ext uri="{FF2B5EF4-FFF2-40B4-BE49-F238E27FC236}">
                  <a16:creationId xmlns:a16="http://schemas.microsoft.com/office/drawing/2014/main" id="{91F246A1-9637-06C7-9BC6-DD9D4C7CD2DA}"/>
                </a:ext>
              </a:extLst>
            </p:cNvPr>
            <p:cNvSpPr txBox="1"/>
            <p:nvPr/>
          </p:nvSpPr>
          <p:spPr>
            <a:xfrm>
              <a:off x="5792126" y="4629994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4" name="TextBox 20">
              <a:extLst>
                <a:ext uri="{FF2B5EF4-FFF2-40B4-BE49-F238E27FC236}">
                  <a16:creationId xmlns:a16="http://schemas.microsoft.com/office/drawing/2014/main" id="{D39EC9F6-A5B0-F3E7-94F9-EC3E3D0AC757}"/>
                </a:ext>
              </a:extLst>
            </p:cNvPr>
            <p:cNvSpPr txBox="1"/>
            <p:nvPr/>
          </p:nvSpPr>
          <p:spPr>
            <a:xfrm>
              <a:off x="6302413" y="4543982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5" name="TextBox 20">
              <a:extLst>
                <a:ext uri="{FF2B5EF4-FFF2-40B4-BE49-F238E27FC236}">
                  <a16:creationId xmlns:a16="http://schemas.microsoft.com/office/drawing/2014/main" id="{8A2329C0-5C86-F9AA-E018-707C39719C69}"/>
                </a:ext>
              </a:extLst>
            </p:cNvPr>
            <p:cNvSpPr txBox="1"/>
            <p:nvPr/>
          </p:nvSpPr>
          <p:spPr>
            <a:xfrm>
              <a:off x="6820398" y="4562237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graphicFrame>
          <p:nvGraphicFramePr>
            <p:cNvPr id="46" name="Chart 45">
              <a:extLst>
                <a:ext uri="{FF2B5EF4-FFF2-40B4-BE49-F238E27FC236}">
                  <a16:creationId xmlns:a16="http://schemas.microsoft.com/office/drawing/2014/main" id="{6F4FE439-6958-35B4-A15E-63009EEB92E1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198055046"/>
                </p:ext>
              </p:extLst>
            </p:nvPr>
          </p:nvGraphicFramePr>
          <p:xfrm>
            <a:off x="504825" y="6928494"/>
            <a:ext cx="3108960" cy="21945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BCA77B3C-DC21-1AF0-501B-A786097E1146}"/>
                </a:ext>
              </a:extLst>
            </p:cNvPr>
            <p:cNvSpPr txBox="1"/>
            <p:nvPr/>
          </p:nvSpPr>
          <p:spPr>
            <a:xfrm>
              <a:off x="566149" y="9182120"/>
              <a:ext cx="31089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ments (Lab)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79D33D3-415F-82CB-1BE8-C5A3E6E7FDCE}"/>
                </a:ext>
              </a:extLst>
            </p:cNvPr>
            <p:cNvSpPr txBox="1"/>
            <p:nvPr/>
          </p:nvSpPr>
          <p:spPr>
            <a:xfrm>
              <a:off x="4147370" y="9182120"/>
              <a:ext cx="31089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ments (Field)</a:t>
              </a:r>
            </a:p>
          </p:txBody>
        </p:sp>
        <p:graphicFrame>
          <p:nvGraphicFramePr>
            <p:cNvPr id="49" name="Chart 5">
              <a:extLst>
                <a:ext uri="{FF2B5EF4-FFF2-40B4-BE49-F238E27FC236}">
                  <a16:creationId xmlns:a16="http://schemas.microsoft.com/office/drawing/2014/main" id="{B82B8AE5-B057-1E07-450F-3E6A4ED75BCC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925974026"/>
                </p:ext>
              </p:extLst>
            </p:nvPr>
          </p:nvGraphicFramePr>
          <p:xfrm>
            <a:off x="4195830" y="6928494"/>
            <a:ext cx="3108960" cy="21945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ADE27FE-70EA-C6C8-6934-1231E4A29C1E}"/>
                </a:ext>
              </a:extLst>
            </p:cNvPr>
            <p:cNvSpPr txBox="1"/>
            <p:nvPr/>
          </p:nvSpPr>
          <p:spPr>
            <a:xfrm>
              <a:off x="3977382" y="6792119"/>
              <a:ext cx="451406" cy="2039737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omatal Conductance (</a:t>
              </a:r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sz="1100" baseline="-25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(mmolm</a:t>
              </a:r>
              <a:r>
                <a:rPr lang="en-US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2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1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US" sz="1100" b="1" i="0" baseline="30000" dirty="0">
                <a:latin typeface="Times New Roman" panose="02020603050405020304" pitchFamily="18" charset="0"/>
                <a:cs typeface="Times New Roman" pitchFamily="18" charset="0"/>
              </a:endParaRPr>
            </a:p>
            <a:p>
              <a:pPr algn="ctr" rtl="0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endPara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20">
              <a:extLst>
                <a:ext uri="{FF2B5EF4-FFF2-40B4-BE49-F238E27FC236}">
                  <a16:creationId xmlns:a16="http://schemas.microsoft.com/office/drawing/2014/main" id="{47D61BB1-6BF2-81B2-D2CD-F224630C33C3}"/>
                </a:ext>
              </a:extLst>
            </p:cNvPr>
            <p:cNvSpPr txBox="1"/>
            <p:nvPr/>
          </p:nvSpPr>
          <p:spPr>
            <a:xfrm>
              <a:off x="990297" y="7163008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11" name="TextBox 20">
              <a:extLst>
                <a:ext uri="{FF2B5EF4-FFF2-40B4-BE49-F238E27FC236}">
                  <a16:creationId xmlns:a16="http://schemas.microsoft.com/office/drawing/2014/main" id="{651DC7ED-F492-D69C-77EA-AE6336955FEE}"/>
                </a:ext>
              </a:extLst>
            </p:cNvPr>
            <p:cNvSpPr txBox="1"/>
            <p:nvPr/>
          </p:nvSpPr>
          <p:spPr>
            <a:xfrm>
              <a:off x="1543457" y="7180100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12" name="TextBox 20">
              <a:extLst>
                <a:ext uri="{FF2B5EF4-FFF2-40B4-BE49-F238E27FC236}">
                  <a16:creationId xmlns:a16="http://schemas.microsoft.com/office/drawing/2014/main" id="{BA0887B0-7229-940C-EE8E-E0677137B5C6}"/>
                </a:ext>
              </a:extLst>
            </p:cNvPr>
            <p:cNvSpPr txBox="1"/>
            <p:nvPr/>
          </p:nvSpPr>
          <p:spPr>
            <a:xfrm>
              <a:off x="2084943" y="7082776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13" name="TextBox 20">
              <a:extLst>
                <a:ext uri="{FF2B5EF4-FFF2-40B4-BE49-F238E27FC236}">
                  <a16:creationId xmlns:a16="http://schemas.microsoft.com/office/drawing/2014/main" id="{127A909A-4A12-2063-B793-279D59DD7506}"/>
                </a:ext>
              </a:extLst>
            </p:cNvPr>
            <p:cNvSpPr txBox="1"/>
            <p:nvPr/>
          </p:nvSpPr>
          <p:spPr>
            <a:xfrm>
              <a:off x="2622073" y="7047593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14" name="TextBox 20">
              <a:extLst>
                <a:ext uri="{FF2B5EF4-FFF2-40B4-BE49-F238E27FC236}">
                  <a16:creationId xmlns:a16="http://schemas.microsoft.com/office/drawing/2014/main" id="{3D198400-E4E2-BBA8-9EFB-9F50ED1A3CC2}"/>
                </a:ext>
              </a:extLst>
            </p:cNvPr>
            <p:cNvSpPr txBox="1"/>
            <p:nvPr/>
          </p:nvSpPr>
          <p:spPr>
            <a:xfrm>
              <a:off x="3170804" y="7165846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471A1186-6910-5D78-3FE1-2DEC2CB5CB52}"/>
                </a:ext>
              </a:extLst>
            </p:cNvPr>
            <p:cNvSpPr txBox="1"/>
            <p:nvPr/>
          </p:nvSpPr>
          <p:spPr>
            <a:xfrm>
              <a:off x="4696954" y="7120093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16" name="TextBox 20">
              <a:extLst>
                <a:ext uri="{FF2B5EF4-FFF2-40B4-BE49-F238E27FC236}">
                  <a16:creationId xmlns:a16="http://schemas.microsoft.com/office/drawing/2014/main" id="{199404E2-C047-09CF-74A6-51E5BB6B0FF3}"/>
                </a:ext>
              </a:extLst>
            </p:cNvPr>
            <p:cNvSpPr txBox="1"/>
            <p:nvPr/>
          </p:nvSpPr>
          <p:spPr>
            <a:xfrm>
              <a:off x="5191961" y="6944158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24" name="TextBox 20">
              <a:extLst>
                <a:ext uri="{FF2B5EF4-FFF2-40B4-BE49-F238E27FC236}">
                  <a16:creationId xmlns:a16="http://schemas.microsoft.com/office/drawing/2014/main" id="{D2BA9DC7-3F93-F7CE-19F5-D498B74C1D6A}"/>
                </a:ext>
              </a:extLst>
            </p:cNvPr>
            <p:cNvSpPr txBox="1"/>
            <p:nvPr/>
          </p:nvSpPr>
          <p:spPr>
            <a:xfrm>
              <a:off x="5696432" y="6949741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50" name="TextBox 20">
              <a:extLst>
                <a:ext uri="{FF2B5EF4-FFF2-40B4-BE49-F238E27FC236}">
                  <a16:creationId xmlns:a16="http://schemas.microsoft.com/office/drawing/2014/main" id="{5283A576-CDD4-CA4C-F19A-2A62C754DF61}"/>
                </a:ext>
              </a:extLst>
            </p:cNvPr>
            <p:cNvSpPr txBox="1"/>
            <p:nvPr/>
          </p:nvSpPr>
          <p:spPr>
            <a:xfrm>
              <a:off x="6196480" y="7238064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52" name="TextBox 20">
              <a:extLst>
                <a:ext uri="{FF2B5EF4-FFF2-40B4-BE49-F238E27FC236}">
                  <a16:creationId xmlns:a16="http://schemas.microsoft.com/office/drawing/2014/main" id="{2CE51F6F-FA8B-1FEF-3522-5013DA77C392}"/>
                </a:ext>
              </a:extLst>
            </p:cNvPr>
            <p:cNvSpPr txBox="1"/>
            <p:nvPr/>
          </p:nvSpPr>
          <p:spPr>
            <a:xfrm>
              <a:off x="6695910" y="7134407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37C2CF48-709E-353C-E2BE-39A0717B8DC0}"/>
              </a:ext>
            </a:extLst>
          </p:cNvPr>
          <p:cNvSpPr txBox="1"/>
          <p:nvPr/>
        </p:nvSpPr>
        <p:spPr>
          <a:xfrm>
            <a:off x="276225" y="8572551"/>
            <a:ext cx="7144881" cy="339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61771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77E976FF-A6A3-4FC2-4678-C297B85CF2F9}"/>
              </a:ext>
            </a:extLst>
          </p:cNvPr>
          <p:cNvGrpSpPr/>
          <p:nvPr/>
        </p:nvGrpSpPr>
        <p:grpSpPr>
          <a:xfrm>
            <a:off x="123825" y="1991518"/>
            <a:ext cx="7214182" cy="6308369"/>
            <a:chOff x="123825" y="1991518"/>
            <a:chExt cx="7214182" cy="6308369"/>
          </a:xfrm>
        </p:grpSpPr>
        <p:graphicFrame>
          <p:nvGraphicFramePr>
            <p:cNvPr id="4" name="Chart 3"/>
            <p:cNvGraphicFramePr/>
            <p:nvPr>
              <p:extLst>
                <p:ext uri="{D42A27DB-BD31-4B8C-83A1-F6EECF244321}">
                  <p14:modId xmlns:p14="http://schemas.microsoft.com/office/powerpoint/2010/main" val="3883316611"/>
                </p:ext>
              </p:extLst>
            </p:nvPr>
          </p:nvGraphicFramePr>
          <p:xfrm>
            <a:off x="532619" y="2448719"/>
            <a:ext cx="3108960" cy="2377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2" name="Chart 11"/>
            <p:cNvGraphicFramePr/>
            <p:nvPr>
              <p:extLst>
                <p:ext uri="{D42A27DB-BD31-4B8C-83A1-F6EECF244321}">
                  <p14:modId xmlns:p14="http://schemas.microsoft.com/office/powerpoint/2010/main" val="1245673086"/>
                </p:ext>
              </p:extLst>
            </p:nvPr>
          </p:nvGraphicFramePr>
          <p:xfrm>
            <a:off x="4145790" y="2448719"/>
            <a:ext cx="3108960" cy="2377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954C6954-F817-569D-377D-432D6614D5E8}"/>
                </a:ext>
              </a:extLst>
            </p:cNvPr>
            <p:cNvSpPr/>
            <p:nvPr/>
          </p:nvSpPr>
          <p:spPr>
            <a:xfrm>
              <a:off x="123825" y="1991518"/>
              <a:ext cx="7214182" cy="63083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9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4CD3172F-2475-DC6B-33D4-7310D7D47452}"/>
                </a:ext>
              </a:extLst>
            </p:cNvPr>
            <p:cNvSpPr/>
            <p:nvPr/>
          </p:nvSpPr>
          <p:spPr>
            <a:xfrm>
              <a:off x="144942" y="1994775"/>
              <a:ext cx="366561" cy="356576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BF44B0F0-07E9-85F9-1434-0A016887ADFD}"/>
                </a:ext>
              </a:extLst>
            </p:cNvPr>
            <p:cNvSpPr/>
            <p:nvPr/>
          </p:nvSpPr>
          <p:spPr>
            <a:xfrm>
              <a:off x="3781425" y="1992628"/>
              <a:ext cx="366561" cy="356576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5BB749B-4AAF-0E18-167B-2596E9D5801D}"/>
                </a:ext>
              </a:extLst>
            </p:cNvPr>
            <p:cNvSpPr txBox="1"/>
            <p:nvPr/>
          </p:nvSpPr>
          <p:spPr>
            <a:xfrm>
              <a:off x="298896" y="2296319"/>
              <a:ext cx="282129" cy="2377440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Leaf Area (cm</a:t>
              </a:r>
              <a:r>
                <a:rPr kumimoji="0" lang="en-US" sz="11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highlight>
                  <a:srgbClr val="FFFF00"/>
                </a:highlight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endParaRPr kumimoji="0" lang="en-US" sz="11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F045077-745A-D119-F2A8-CA3C368B96FD}"/>
                </a:ext>
              </a:extLst>
            </p:cNvPr>
            <p:cNvSpPr txBox="1"/>
            <p:nvPr/>
          </p:nvSpPr>
          <p:spPr>
            <a:xfrm>
              <a:off x="3956496" y="2296319"/>
              <a:ext cx="282129" cy="2377440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Leaf Area (cm</a:t>
              </a:r>
              <a:r>
                <a:rPr kumimoji="0" lang="en-US" sz="11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highlight>
                  <a:srgbClr val="FFFF00"/>
                </a:highlight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endParaRPr kumimoji="0" lang="en-US" sz="11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682929F-E92A-8293-341D-29C54C8DD3FA}"/>
                </a:ext>
              </a:extLst>
            </p:cNvPr>
            <p:cNvSpPr txBox="1"/>
            <p:nvPr/>
          </p:nvSpPr>
          <p:spPr>
            <a:xfrm>
              <a:off x="569584" y="4762520"/>
              <a:ext cx="31089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ments (Lab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E3A631C-5F5A-00EB-AE99-FE4C8DC15FE5}"/>
                </a:ext>
              </a:extLst>
            </p:cNvPr>
            <p:cNvSpPr txBox="1"/>
            <p:nvPr/>
          </p:nvSpPr>
          <p:spPr>
            <a:xfrm>
              <a:off x="4145790" y="4762520"/>
              <a:ext cx="31089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ments (Field)</a:t>
              </a:r>
            </a:p>
          </p:txBody>
        </p:sp>
        <p:sp>
          <p:nvSpPr>
            <p:cNvPr id="20" name="TextBox 20">
              <a:extLst>
                <a:ext uri="{FF2B5EF4-FFF2-40B4-BE49-F238E27FC236}">
                  <a16:creationId xmlns:a16="http://schemas.microsoft.com/office/drawing/2014/main" id="{EE9D331E-DBFE-C34F-20A6-57E1A646C02F}"/>
                </a:ext>
              </a:extLst>
            </p:cNvPr>
            <p:cNvSpPr txBox="1"/>
            <p:nvPr/>
          </p:nvSpPr>
          <p:spPr>
            <a:xfrm>
              <a:off x="962096" y="2930375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b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779D728-5B71-1CCC-EB10-76959853024F}"/>
                </a:ext>
              </a:extLst>
            </p:cNvPr>
            <p:cNvSpPr txBox="1"/>
            <p:nvPr/>
          </p:nvSpPr>
          <p:spPr>
            <a:xfrm>
              <a:off x="1484200" y="2829496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b</a:t>
              </a:r>
            </a:p>
          </p:txBody>
        </p:sp>
        <p:sp>
          <p:nvSpPr>
            <p:cNvPr id="22" name="TextBox 20">
              <a:extLst>
                <a:ext uri="{FF2B5EF4-FFF2-40B4-BE49-F238E27FC236}">
                  <a16:creationId xmlns:a16="http://schemas.microsoft.com/office/drawing/2014/main" id="{46269880-3D18-A760-D217-46288AF49918}"/>
                </a:ext>
              </a:extLst>
            </p:cNvPr>
            <p:cNvSpPr txBox="1"/>
            <p:nvPr/>
          </p:nvSpPr>
          <p:spPr>
            <a:xfrm>
              <a:off x="2014850" y="2656606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b</a:t>
              </a:r>
            </a:p>
          </p:txBody>
        </p:sp>
        <p:sp>
          <p:nvSpPr>
            <p:cNvPr id="23" name="TextBox 20">
              <a:extLst>
                <a:ext uri="{FF2B5EF4-FFF2-40B4-BE49-F238E27FC236}">
                  <a16:creationId xmlns:a16="http://schemas.microsoft.com/office/drawing/2014/main" id="{24AF4095-2C72-5F4E-B888-F55AA9D8F9DC}"/>
                </a:ext>
              </a:extLst>
            </p:cNvPr>
            <p:cNvSpPr txBox="1"/>
            <p:nvPr/>
          </p:nvSpPr>
          <p:spPr>
            <a:xfrm>
              <a:off x="2530878" y="2746924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b</a:t>
              </a:r>
            </a:p>
          </p:txBody>
        </p:sp>
        <p:sp>
          <p:nvSpPr>
            <p:cNvPr id="24" name="TextBox 20">
              <a:extLst>
                <a:ext uri="{FF2B5EF4-FFF2-40B4-BE49-F238E27FC236}">
                  <a16:creationId xmlns:a16="http://schemas.microsoft.com/office/drawing/2014/main" id="{22568577-FE09-7544-20E5-BEAAE9C4BB78}"/>
                </a:ext>
              </a:extLst>
            </p:cNvPr>
            <p:cNvSpPr txBox="1"/>
            <p:nvPr/>
          </p:nvSpPr>
          <p:spPr>
            <a:xfrm>
              <a:off x="3067213" y="2540888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25" name="TextBox 20">
              <a:extLst>
                <a:ext uri="{FF2B5EF4-FFF2-40B4-BE49-F238E27FC236}">
                  <a16:creationId xmlns:a16="http://schemas.microsoft.com/office/drawing/2014/main" id="{1BF00D26-EF35-05AD-4EA9-D16F7CA4F403}"/>
                </a:ext>
              </a:extLst>
            </p:cNvPr>
            <p:cNvSpPr txBox="1"/>
            <p:nvPr/>
          </p:nvSpPr>
          <p:spPr>
            <a:xfrm>
              <a:off x="4584614" y="2673698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26" name="TextBox 20">
              <a:extLst>
                <a:ext uri="{FF2B5EF4-FFF2-40B4-BE49-F238E27FC236}">
                  <a16:creationId xmlns:a16="http://schemas.microsoft.com/office/drawing/2014/main" id="{C2AC4D16-2DD8-7A42-F5D2-094FD3656922}"/>
                </a:ext>
              </a:extLst>
            </p:cNvPr>
            <p:cNvSpPr txBox="1"/>
            <p:nvPr/>
          </p:nvSpPr>
          <p:spPr>
            <a:xfrm>
              <a:off x="5130613" y="2655574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7" name="TextBox 20">
              <a:extLst>
                <a:ext uri="{FF2B5EF4-FFF2-40B4-BE49-F238E27FC236}">
                  <a16:creationId xmlns:a16="http://schemas.microsoft.com/office/drawing/2014/main" id="{2B7F31ED-24B4-0B8C-A16D-C55340DEC612}"/>
                </a:ext>
              </a:extLst>
            </p:cNvPr>
            <p:cNvSpPr txBox="1"/>
            <p:nvPr/>
          </p:nvSpPr>
          <p:spPr>
            <a:xfrm>
              <a:off x="5663496" y="2655574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28" name="TextBox 20">
              <a:extLst>
                <a:ext uri="{FF2B5EF4-FFF2-40B4-BE49-F238E27FC236}">
                  <a16:creationId xmlns:a16="http://schemas.microsoft.com/office/drawing/2014/main" id="{7BFD4A32-A935-3458-1D06-6B899478B36F}"/>
                </a:ext>
              </a:extLst>
            </p:cNvPr>
            <p:cNvSpPr txBox="1"/>
            <p:nvPr/>
          </p:nvSpPr>
          <p:spPr>
            <a:xfrm>
              <a:off x="6195236" y="2633221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29" name="TextBox 20">
              <a:extLst>
                <a:ext uri="{FF2B5EF4-FFF2-40B4-BE49-F238E27FC236}">
                  <a16:creationId xmlns:a16="http://schemas.microsoft.com/office/drawing/2014/main" id="{81EBD1FB-2184-F22E-4333-BAFAEF8C5CDA}"/>
                </a:ext>
              </a:extLst>
            </p:cNvPr>
            <p:cNvSpPr txBox="1"/>
            <p:nvPr/>
          </p:nvSpPr>
          <p:spPr>
            <a:xfrm>
              <a:off x="6737685" y="2633221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422859E-F5DD-7F4A-6774-0D0A0C717BAE}"/>
                </a:ext>
              </a:extLst>
            </p:cNvPr>
            <p:cNvSpPr txBox="1"/>
            <p:nvPr/>
          </p:nvSpPr>
          <p:spPr>
            <a:xfrm>
              <a:off x="1899096" y="5649119"/>
              <a:ext cx="282129" cy="2039737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pPr algn="ctr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ber Weight (g/plant)</a:t>
              </a:r>
              <a:endParaRPr lang="en-US" sz="1100" b="1" i="0" baseline="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itchFamily="18" charset="0"/>
              </a:endParaRPr>
            </a:p>
            <a:p>
              <a:pPr algn="ctr" rtl="0">
                <a:defRPr sz="12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endPara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C3CBEA7-F82F-9230-9282-1EE8FC2654E8}"/>
                </a:ext>
              </a:extLst>
            </p:cNvPr>
            <p:cNvSpPr txBox="1"/>
            <p:nvPr/>
          </p:nvSpPr>
          <p:spPr>
            <a:xfrm>
              <a:off x="2135150" y="7949793"/>
              <a:ext cx="31089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ments (Field)</a:t>
              </a:r>
            </a:p>
          </p:txBody>
        </p:sp>
        <p:graphicFrame>
          <p:nvGraphicFramePr>
            <p:cNvPr id="40" name="Chart 39">
              <a:extLst>
                <a:ext uri="{FF2B5EF4-FFF2-40B4-BE49-F238E27FC236}">
                  <a16:creationId xmlns:a16="http://schemas.microsoft.com/office/drawing/2014/main" id="{B198D33D-55AD-8EDF-447D-C28BEDE535F6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210042984"/>
                </p:ext>
              </p:extLst>
            </p:nvPr>
          </p:nvGraphicFramePr>
          <p:xfrm>
            <a:off x="2135150" y="5859579"/>
            <a:ext cx="3108960" cy="20116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41" name="TextBox 20">
              <a:extLst>
                <a:ext uri="{FF2B5EF4-FFF2-40B4-BE49-F238E27FC236}">
                  <a16:creationId xmlns:a16="http://schemas.microsoft.com/office/drawing/2014/main" id="{E4BF7DF9-C459-5D27-2C3E-5F430C94B5D2}"/>
                </a:ext>
              </a:extLst>
            </p:cNvPr>
            <p:cNvSpPr txBox="1"/>
            <p:nvPr/>
          </p:nvSpPr>
          <p:spPr>
            <a:xfrm>
              <a:off x="4231774" y="6089543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42" name="TextBox 20">
              <a:extLst>
                <a:ext uri="{FF2B5EF4-FFF2-40B4-BE49-F238E27FC236}">
                  <a16:creationId xmlns:a16="http://schemas.microsoft.com/office/drawing/2014/main" id="{B44C83C4-C739-5E7A-8E9B-FECA72EF9E04}"/>
                </a:ext>
              </a:extLst>
            </p:cNvPr>
            <p:cNvSpPr txBox="1"/>
            <p:nvPr/>
          </p:nvSpPr>
          <p:spPr>
            <a:xfrm>
              <a:off x="2566341" y="6444371"/>
              <a:ext cx="344320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</a:t>
              </a:r>
            </a:p>
          </p:txBody>
        </p:sp>
        <p:sp>
          <p:nvSpPr>
            <p:cNvPr id="43" name="TextBox 20">
              <a:extLst>
                <a:ext uri="{FF2B5EF4-FFF2-40B4-BE49-F238E27FC236}">
                  <a16:creationId xmlns:a16="http://schemas.microsoft.com/office/drawing/2014/main" id="{5F2622BF-BC8B-D70A-3298-6956558DB042}"/>
                </a:ext>
              </a:extLst>
            </p:cNvPr>
            <p:cNvSpPr txBox="1"/>
            <p:nvPr/>
          </p:nvSpPr>
          <p:spPr>
            <a:xfrm>
              <a:off x="3711456" y="5950979"/>
              <a:ext cx="284562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44" name="TextBox 20">
              <a:extLst>
                <a:ext uri="{FF2B5EF4-FFF2-40B4-BE49-F238E27FC236}">
                  <a16:creationId xmlns:a16="http://schemas.microsoft.com/office/drawing/2014/main" id="{4689621E-8A68-1300-A571-7D926FBDB65A}"/>
                </a:ext>
              </a:extLst>
            </p:cNvPr>
            <p:cNvSpPr txBox="1"/>
            <p:nvPr/>
          </p:nvSpPr>
          <p:spPr>
            <a:xfrm>
              <a:off x="3154168" y="5887169"/>
              <a:ext cx="284562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45" name="TextBox 20">
              <a:extLst>
                <a:ext uri="{FF2B5EF4-FFF2-40B4-BE49-F238E27FC236}">
                  <a16:creationId xmlns:a16="http://schemas.microsoft.com/office/drawing/2014/main" id="{B024DD3E-3043-D3F8-EDCC-CDAA2D29C0A4}"/>
                </a:ext>
              </a:extLst>
            </p:cNvPr>
            <p:cNvSpPr txBox="1"/>
            <p:nvPr/>
          </p:nvSpPr>
          <p:spPr>
            <a:xfrm>
              <a:off x="4793528" y="5875217"/>
              <a:ext cx="284562" cy="16927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lIns="0" tIns="0" rIns="0" bIns="0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A27EA58E-3D5E-C389-D70E-335F2BB437DD}"/>
                </a:ext>
              </a:extLst>
            </p:cNvPr>
            <p:cNvSpPr/>
            <p:nvPr/>
          </p:nvSpPr>
          <p:spPr>
            <a:xfrm>
              <a:off x="1738464" y="5261972"/>
              <a:ext cx="366561" cy="356576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28079668-C51B-F596-594E-3E8EEAACA463}"/>
              </a:ext>
            </a:extLst>
          </p:cNvPr>
          <p:cNvSpPr txBox="1"/>
          <p:nvPr/>
        </p:nvSpPr>
        <p:spPr>
          <a:xfrm>
            <a:off x="428625" y="8516949"/>
            <a:ext cx="6500979" cy="339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6</TotalTime>
  <Words>197</Words>
  <Application>Microsoft Office PowerPoint</Application>
  <PresentationFormat>Custom</PresentationFormat>
  <Paragraphs>7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rial</vt:lpstr>
      <vt:lpstr>Calibri</vt:lpstr>
      <vt:lpstr>Times New Roman</vt:lpstr>
      <vt:lpstr>Office Theme</vt:lpstr>
      <vt:lpstr>1_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afi Ullah Wazir</dc:creator>
  <cp:lastModifiedBy>Raza Ahmad</cp:lastModifiedBy>
  <cp:revision>83</cp:revision>
  <dcterms:created xsi:type="dcterms:W3CDTF">2023-12-22T17:29:05Z</dcterms:created>
  <dcterms:modified xsi:type="dcterms:W3CDTF">2024-03-21T16:57:47Z</dcterms:modified>
</cp:coreProperties>
</file>